
<file path=[Content_Types].xml><?xml version="1.0" encoding="utf-8"?>
<Types xmlns="http://schemas.openxmlformats.org/package/2006/content-types"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9" r:id="rId2"/>
  </p:sldIdLst>
  <p:sldSz cx="12192000" cy="6858000"/>
  <p:notesSz cx="12192000" cy="68580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344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F6D035B-5901-405E-82AE-37BABCB7EA08}" v="1" dt="2025-11-03T12:51:04.512"/>
  </p1510:revLst>
</p1510:revInfo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45"/>
    <p:restoredTop sz="94700"/>
  </p:normalViewPr>
  <p:slideViewPr>
    <p:cSldViewPr>
      <p:cViewPr varScale="1">
        <p:scale>
          <a:sx n="72" d="100"/>
          <a:sy n="72" d="100"/>
        </p:scale>
        <p:origin x="1020" y="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6905625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B4676F-88A8-49D4-A30B-B22C220EB3CA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038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219200" y="3300413"/>
            <a:ext cx="97536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6905625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5D89A2-92B1-4B60-851F-3176F78FC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7812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5D89A2-92B1-4B60-851F-3176F78FC93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2588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75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4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3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75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3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wo Conten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0" y="0"/>
            <a:ext cx="12192000" cy="1532890"/>
          </a:xfrm>
          <a:custGeom>
            <a:avLst/>
            <a:gdLst/>
            <a:ahLst/>
            <a:cxnLst/>
            <a:rect l="l" t="t" r="r" b="b"/>
            <a:pathLst>
              <a:path w="12192000" h="1532890">
                <a:moveTo>
                  <a:pt x="12192000" y="0"/>
                </a:moveTo>
                <a:lnTo>
                  <a:pt x="0" y="0"/>
                </a:lnTo>
                <a:lnTo>
                  <a:pt x="0" y="1532471"/>
                </a:lnTo>
                <a:lnTo>
                  <a:pt x="3448" y="1506267"/>
                </a:lnTo>
                <a:lnTo>
                  <a:pt x="13434" y="1463231"/>
                </a:lnTo>
                <a:lnTo>
                  <a:pt x="27560" y="1420310"/>
                </a:lnTo>
                <a:lnTo>
                  <a:pt x="45594" y="1378004"/>
                </a:lnTo>
                <a:lnTo>
                  <a:pt x="67304" y="1336815"/>
                </a:lnTo>
                <a:lnTo>
                  <a:pt x="92457" y="1297244"/>
                </a:lnTo>
                <a:lnTo>
                  <a:pt x="120820" y="1259792"/>
                </a:lnTo>
                <a:lnTo>
                  <a:pt x="152160" y="1224961"/>
                </a:lnTo>
                <a:lnTo>
                  <a:pt x="186245" y="1193253"/>
                </a:lnTo>
                <a:lnTo>
                  <a:pt x="222842" y="1165168"/>
                </a:lnTo>
                <a:lnTo>
                  <a:pt x="261719" y="1141208"/>
                </a:lnTo>
                <a:lnTo>
                  <a:pt x="302643" y="1121874"/>
                </a:lnTo>
                <a:lnTo>
                  <a:pt x="345380" y="1107668"/>
                </a:lnTo>
                <a:lnTo>
                  <a:pt x="389700" y="1099091"/>
                </a:lnTo>
                <a:lnTo>
                  <a:pt x="435368" y="1096645"/>
                </a:lnTo>
                <a:lnTo>
                  <a:pt x="12192000" y="1095059"/>
                </a:lnTo>
                <a:lnTo>
                  <a:pt x="12192000" y="0"/>
                </a:lnTo>
                <a:close/>
              </a:path>
            </a:pathLst>
          </a:custGeom>
          <a:solidFill>
            <a:srgbClr val="64AA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75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3/2025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Only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bg object 16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2000" cy="1085850"/>
          </a:xfrm>
          <a:prstGeom prst="rect">
            <a:avLst/>
          </a:prstGeom>
        </p:spPr>
      </p:pic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75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3/2025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Blank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bg object 16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2000" cy="1085850"/>
          </a:xfrm>
          <a:prstGeom prst="rect">
            <a:avLst/>
          </a:prstGeom>
        </p:spPr>
      </p:pic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3/2025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294957" y="79374"/>
            <a:ext cx="7959725" cy="8407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75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8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4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3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image" Target="../media/image3.jpg"/><Relationship Id="rId26" Type="http://schemas.openxmlformats.org/officeDocument/2006/relationships/image" Target="../media/image11.png"/><Relationship Id="rId3" Type="http://schemas.openxmlformats.org/officeDocument/2006/relationships/tags" Target="../tags/tag3.xml"/><Relationship Id="rId21" Type="http://schemas.openxmlformats.org/officeDocument/2006/relationships/image" Target="../media/image6.png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image" Target="../media/image2.png"/><Relationship Id="rId25" Type="http://schemas.openxmlformats.org/officeDocument/2006/relationships/image" Target="../media/image10.png"/><Relationship Id="rId2" Type="http://schemas.openxmlformats.org/officeDocument/2006/relationships/tags" Target="../tags/tag2.xml"/><Relationship Id="rId16" Type="http://schemas.openxmlformats.org/officeDocument/2006/relationships/notesSlide" Target="../notesSlides/notesSlide1.xml"/><Relationship Id="rId20" Type="http://schemas.openxmlformats.org/officeDocument/2006/relationships/image" Target="../media/image5.png"/><Relationship Id="rId29" Type="http://schemas.openxmlformats.org/officeDocument/2006/relationships/image" Target="../media/image14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image" Target="../media/image9.png"/><Relationship Id="rId32" Type="http://schemas.openxmlformats.org/officeDocument/2006/relationships/image" Target="../media/image17.png"/><Relationship Id="rId5" Type="http://schemas.openxmlformats.org/officeDocument/2006/relationships/tags" Target="../tags/tag5.xml"/><Relationship Id="rId15" Type="http://schemas.openxmlformats.org/officeDocument/2006/relationships/slideLayout" Target="../slideLayouts/slideLayout2.xml"/><Relationship Id="rId23" Type="http://schemas.openxmlformats.org/officeDocument/2006/relationships/image" Target="../media/image8.png"/><Relationship Id="rId28" Type="http://schemas.openxmlformats.org/officeDocument/2006/relationships/image" Target="../media/image13.png"/><Relationship Id="rId10" Type="http://schemas.openxmlformats.org/officeDocument/2006/relationships/tags" Target="../tags/tag10.xml"/><Relationship Id="rId19" Type="http://schemas.openxmlformats.org/officeDocument/2006/relationships/image" Target="../media/image4.png"/><Relationship Id="rId31" Type="http://schemas.openxmlformats.org/officeDocument/2006/relationships/image" Target="../media/image16.png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image" Target="../media/image7.png"/><Relationship Id="rId27" Type="http://schemas.openxmlformats.org/officeDocument/2006/relationships/image" Target="../media/image12.png"/><Relationship Id="rId30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>
          <a:extLst>
            <a:ext uri="{FF2B5EF4-FFF2-40B4-BE49-F238E27FC236}">
              <a16:creationId xmlns:a16="http://schemas.microsoft.com/office/drawing/2014/main" id="{5ABC317F-35DF-255A-5836-BB54C7ACC20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object 2">
            <a:extLst>
              <a:ext uri="{FF2B5EF4-FFF2-40B4-BE49-F238E27FC236}">
                <a16:creationId xmlns:a16="http://schemas.microsoft.com/office/drawing/2014/main" id="{311F6A70-004E-C648-5546-5429C516A8EB}"/>
              </a:ext>
            </a:extLst>
          </p:cNvPr>
          <p:cNvGrpSpPr/>
          <p:nvPr/>
        </p:nvGrpSpPr>
        <p:grpSpPr>
          <a:xfrm>
            <a:off x="-808990" y="0"/>
            <a:ext cx="13000990" cy="2045970"/>
            <a:chOff x="-808722" y="0"/>
            <a:chExt cx="13000990" cy="2045970"/>
          </a:xfrm>
        </p:grpSpPr>
        <p:sp>
          <p:nvSpPr>
            <p:cNvPr id="3" name="object 3">
              <a:extLst>
                <a:ext uri="{FF2B5EF4-FFF2-40B4-BE49-F238E27FC236}">
                  <a16:creationId xmlns:a16="http://schemas.microsoft.com/office/drawing/2014/main" id="{1AF98B34-5D4E-0336-67BA-4B01A266F25D}"/>
                </a:ext>
              </a:extLst>
            </p:cNvPr>
            <p:cNvSpPr/>
            <p:nvPr/>
          </p:nvSpPr>
          <p:spPr>
            <a:xfrm>
              <a:off x="-808722" y="504879"/>
              <a:ext cx="13000990" cy="1541145"/>
            </a:xfrm>
            <a:custGeom>
              <a:avLst/>
              <a:gdLst/>
              <a:ahLst/>
              <a:cxnLst/>
              <a:rect l="l" t="t" r="r" b="b"/>
              <a:pathLst>
                <a:path w="13000990" h="1541145">
                  <a:moveTo>
                    <a:pt x="13000722" y="0"/>
                  </a:moveTo>
                  <a:lnTo>
                    <a:pt x="10498392" y="9771"/>
                  </a:lnTo>
                  <a:lnTo>
                    <a:pt x="0" y="20495"/>
                  </a:lnTo>
                  <a:lnTo>
                    <a:pt x="808724" y="20495"/>
                  </a:lnTo>
                  <a:lnTo>
                    <a:pt x="808725" y="1541084"/>
                  </a:lnTo>
                  <a:lnTo>
                    <a:pt x="812795" y="1510474"/>
                  </a:lnTo>
                  <a:lnTo>
                    <a:pt x="823390" y="1463208"/>
                  </a:lnTo>
                  <a:lnTo>
                    <a:pt x="837875" y="1417848"/>
                  </a:lnTo>
                  <a:lnTo>
                    <a:pt x="856051" y="1374660"/>
                  </a:lnTo>
                  <a:lnTo>
                    <a:pt x="877716" y="1333908"/>
                  </a:lnTo>
                  <a:lnTo>
                    <a:pt x="902672" y="1295856"/>
                  </a:lnTo>
                  <a:lnTo>
                    <a:pt x="930718" y="1260769"/>
                  </a:lnTo>
                  <a:lnTo>
                    <a:pt x="961652" y="1228912"/>
                  </a:lnTo>
                  <a:lnTo>
                    <a:pt x="995276" y="1200549"/>
                  </a:lnTo>
                  <a:lnTo>
                    <a:pt x="1031389" y="1175944"/>
                  </a:lnTo>
                  <a:lnTo>
                    <a:pt x="1069790" y="1155363"/>
                  </a:lnTo>
                  <a:lnTo>
                    <a:pt x="1110279" y="1139069"/>
                  </a:lnTo>
                  <a:lnTo>
                    <a:pt x="1152260" y="1127438"/>
                  </a:lnTo>
                  <a:lnTo>
                    <a:pt x="1151957" y="1127438"/>
                  </a:lnTo>
                  <a:lnTo>
                    <a:pt x="1196722" y="1120404"/>
                  </a:lnTo>
                  <a:lnTo>
                    <a:pt x="1266629" y="1117692"/>
                  </a:lnTo>
                  <a:lnTo>
                    <a:pt x="1266434" y="1117692"/>
                  </a:lnTo>
                  <a:lnTo>
                    <a:pt x="1316503" y="1116567"/>
                  </a:lnTo>
                  <a:lnTo>
                    <a:pt x="1315912" y="1116567"/>
                  </a:lnTo>
                  <a:lnTo>
                    <a:pt x="2444149" y="1109186"/>
                  </a:lnTo>
                  <a:lnTo>
                    <a:pt x="13000722" y="1107892"/>
                  </a:lnTo>
                  <a:lnTo>
                    <a:pt x="13000722" y="0"/>
                  </a:lnTo>
                  <a:close/>
                </a:path>
                <a:path w="13000990" h="1541145">
                  <a:moveTo>
                    <a:pt x="13000722" y="1107892"/>
                  </a:moveTo>
                  <a:lnTo>
                    <a:pt x="8331414" y="1107892"/>
                  </a:lnTo>
                  <a:lnTo>
                    <a:pt x="13000722" y="1128085"/>
                  </a:lnTo>
                  <a:lnTo>
                    <a:pt x="13000722" y="1107892"/>
                  </a:lnTo>
                  <a:close/>
                </a:path>
              </a:pathLst>
            </a:custGeom>
            <a:solidFill>
              <a:srgbClr val="0092F7"/>
            </a:solidFill>
          </p:spPr>
          <p:txBody>
            <a:bodyPr wrap="square" lIns="0" tIns="0" rIns="0" bIns="0" rtlCol="0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" name="object 4">
              <a:extLst>
                <a:ext uri="{FF2B5EF4-FFF2-40B4-BE49-F238E27FC236}">
                  <a16:creationId xmlns:a16="http://schemas.microsoft.com/office/drawing/2014/main" id="{A2AE8DFA-49DC-1B0B-938D-51EDFAB42136}"/>
                </a:ext>
              </a:extLst>
            </p:cNvPr>
            <p:cNvSpPr/>
            <p:nvPr/>
          </p:nvSpPr>
          <p:spPr>
            <a:xfrm>
              <a:off x="0" y="0"/>
              <a:ext cx="12192000" cy="1532890"/>
            </a:xfrm>
            <a:custGeom>
              <a:avLst/>
              <a:gdLst/>
              <a:ahLst/>
              <a:cxnLst/>
              <a:rect l="l" t="t" r="r" b="b"/>
              <a:pathLst>
                <a:path w="12192000" h="1532890">
                  <a:moveTo>
                    <a:pt x="12192000" y="0"/>
                  </a:moveTo>
                  <a:lnTo>
                    <a:pt x="0" y="0"/>
                  </a:lnTo>
                  <a:lnTo>
                    <a:pt x="0" y="1532471"/>
                  </a:lnTo>
                  <a:lnTo>
                    <a:pt x="3448" y="1506267"/>
                  </a:lnTo>
                  <a:lnTo>
                    <a:pt x="13434" y="1463231"/>
                  </a:lnTo>
                  <a:lnTo>
                    <a:pt x="27560" y="1420310"/>
                  </a:lnTo>
                  <a:lnTo>
                    <a:pt x="45594" y="1378004"/>
                  </a:lnTo>
                  <a:lnTo>
                    <a:pt x="67304" y="1336815"/>
                  </a:lnTo>
                  <a:lnTo>
                    <a:pt x="92457" y="1297244"/>
                  </a:lnTo>
                  <a:lnTo>
                    <a:pt x="120820" y="1259792"/>
                  </a:lnTo>
                  <a:lnTo>
                    <a:pt x="152160" y="1224961"/>
                  </a:lnTo>
                  <a:lnTo>
                    <a:pt x="186245" y="1193253"/>
                  </a:lnTo>
                  <a:lnTo>
                    <a:pt x="222842" y="1165168"/>
                  </a:lnTo>
                  <a:lnTo>
                    <a:pt x="261719" y="1141208"/>
                  </a:lnTo>
                  <a:lnTo>
                    <a:pt x="302643" y="1121874"/>
                  </a:lnTo>
                  <a:lnTo>
                    <a:pt x="345380" y="1107668"/>
                  </a:lnTo>
                  <a:lnTo>
                    <a:pt x="389700" y="1099091"/>
                  </a:lnTo>
                  <a:lnTo>
                    <a:pt x="435368" y="1096645"/>
                  </a:lnTo>
                  <a:lnTo>
                    <a:pt x="12192000" y="1095059"/>
                  </a:lnTo>
                  <a:lnTo>
                    <a:pt x="12192000" y="0"/>
                  </a:lnTo>
                  <a:close/>
                </a:path>
              </a:pathLst>
            </a:custGeom>
            <a:solidFill>
              <a:srgbClr val="003969"/>
            </a:solidFill>
          </p:spPr>
          <p:txBody>
            <a:bodyPr wrap="square" lIns="0" tIns="0" rIns="0" bIns="0" rtlCol="0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pic>
        <p:nvPicPr>
          <p:cNvPr id="5" name="object 5">
            <a:extLst>
              <a:ext uri="{FF2B5EF4-FFF2-40B4-BE49-F238E27FC236}">
                <a16:creationId xmlns:a16="http://schemas.microsoft.com/office/drawing/2014/main" id="{5B23DE2B-4B37-DB9F-3D6E-D66BD96A0CD1}"/>
              </a:ext>
            </a:extLst>
          </p:cNvPr>
          <p:cNvPicPr/>
          <p:nvPr/>
        </p:nvPicPr>
        <p:blipFill>
          <a:blip r:embed="rId17" cstate="print"/>
          <a:stretch>
            <a:fillRect/>
          </a:stretch>
        </p:blipFill>
        <p:spPr>
          <a:xfrm>
            <a:off x="7488509" y="5700365"/>
            <a:ext cx="4705350" cy="428625"/>
          </a:xfrm>
          <a:prstGeom prst="rect">
            <a:avLst/>
          </a:prstGeom>
        </p:spPr>
      </p:pic>
      <p:pic>
        <p:nvPicPr>
          <p:cNvPr id="6" name="object 6">
            <a:extLst>
              <a:ext uri="{FF2B5EF4-FFF2-40B4-BE49-F238E27FC236}">
                <a16:creationId xmlns:a16="http://schemas.microsoft.com/office/drawing/2014/main" id="{111F3DBE-3278-531C-5736-6715FCA0BBC8}"/>
              </a:ext>
            </a:extLst>
          </p:cNvPr>
          <p:cNvPicPr/>
          <p:nvPr/>
        </p:nvPicPr>
        <p:blipFill>
          <a:blip r:embed="rId18" cstate="print"/>
          <a:stretch>
            <a:fillRect/>
          </a:stretch>
        </p:blipFill>
        <p:spPr>
          <a:xfrm>
            <a:off x="7693727" y="6222107"/>
            <a:ext cx="543673" cy="581025"/>
          </a:xfrm>
          <a:prstGeom prst="rect">
            <a:avLst/>
          </a:prstGeom>
        </p:spPr>
      </p:pic>
      <p:sp>
        <p:nvSpPr>
          <p:cNvPr id="7" name="object 7">
            <a:extLst>
              <a:ext uri="{FF2B5EF4-FFF2-40B4-BE49-F238E27FC236}">
                <a16:creationId xmlns:a16="http://schemas.microsoft.com/office/drawing/2014/main" id="{C245F458-46E4-63BC-1CC9-7F5DD9795517}"/>
              </a:ext>
            </a:extLst>
          </p:cNvPr>
          <p:cNvSpPr txBox="1"/>
          <p:nvPr/>
        </p:nvSpPr>
        <p:spPr>
          <a:xfrm>
            <a:off x="8301282" y="6169404"/>
            <a:ext cx="2322195" cy="47370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0" lvl="0" indent="0" defTabSz="914400" eaLnBrk="1" fontAlgn="auto" latinLnBrk="0" hangingPunct="1">
              <a:lnSpc>
                <a:spcPct val="100000"/>
              </a:lnSpc>
              <a:spcBef>
                <a:spcPts val="1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sz="1800" b="1" i="0" u="none" strike="noStrike" kern="0" cap="none" spc="0" normalizeH="0" baseline="0" noProof="0" dirty="0">
                <a:ln>
                  <a:noFill/>
                </a:ln>
                <a:solidFill>
                  <a:srgbClr val="296CC0"/>
                </a:solidFill>
                <a:effectLst/>
                <a:uLnTx/>
                <a:uFillTx/>
                <a:latin typeface="Arial"/>
                <a:cs typeface="Arial"/>
              </a:rPr>
              <a:t>Pediatric</a:t>
            </a:r>
            <a:r>
              <a:rPr kumimoji="0" sz="1800" b="1" i="0" u="none" strike="noStrike" kern="0" cap="none" spc="-45" normalizeH="0" baseline="0" noProof="0" dirty="0">
                <a:ln>
                  <a:noFill/>
                </a:ln>
                <a:solidFill>
                  <a:srgbClr val="296CC0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1800" b="1" i="0" u="none" strike="noStrike" kern="0" cap="none" spc="-10" normalizeH="0" baseline="0" noProof="0" dirty="0">
                <a:ln>
                  <a:noFill/>
                </a:ln>
                <a:solidFill>
                  <a:srgbClr val="296CC0"/>
                </a:solidFill>
                <a:effectLst/>
                <a:uLnTx/>
                <a:uFillTx/>
                <a:latin typeface="Arial"/>
                <a:cs typeface="Arial"/>
              </a:rPr>
              <a:t>Nephrology</a:t>
            </a: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  <a:p>
            <a:pPr marL="12700" marR="0" lvl="0" indent="0" defTabSz="914400" eaLnBrk="1" fontAlgn="auto" latinLnBrk="0" hangingPunct="1">
              <a:lnSpc>
                <a:spcPct val="100000"/>
              </a:lnSpc>
              <a:spcBef>
                <a:spcPts val="4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sz="11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Journal</a:t>
            </a:r>
            <a:r>
              <a:rPr kumimoji="0" sz="1100" b="0" i="0" u="none" strike="noStrike" kern="0" cap="none" spc="-5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11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of</a:t>
            </a:r>
            <a:r>
              <a:rPr kumimoji="0" sz="1100" b="0" i="0" u="none" strike="noStrike" kern="0" cap="none" spc="-3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1100" b="0" i="0" u="none" strike="noStrike" kern="0" cap="none" spc="-25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the</a:t>
            </a:r>
            <a:endParaRPr kumimoji="0" sz="11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8" name="object 8">
            <a:extLst>
              <a:ext uri="{FF2B5EF4-FFF2-40B4-BE49-F238E27FC236}">
                <a16:creationId xmlns:a16="http://schemas.microsoft.com/office/drawing/2014/main" id="{5DFC7975-642C-6B88-9E89-34CF8017B9E2}"/>
              </a:ext>
            </a:extLst>
          </p:cNvPr>
          <p:cNvSpPr/>
          <p:nvPr/>
        </p:nvSpPr>
        <p:spPr>
          <a:xfrm>
            <a:off x="10267950" y="0"/>
            <a:ext cx="1924050" cy="1095375"/>
          </a:xfrm>
          <a:custGeom>
            <a:avLst/>
            <a:gdLst/>
            <a:ahLst/>
            <a:cxnLst/>
            <a:rect l="l" t="t" r="r" b="b"/>
            <a:pathLst>
              <a:path w="1924050" h="1095375">
                <a:moveTo>
                  <a:pt x="0" y="0"/>
                </a:moveTo>
                <a:lnTo>
                  <a:pt x="0" y="1095375"/>
                </a:lnTo>
                <a:lnTo>
                  <a:pt x="1924050" y="1095375"/>
                </a:lnTo>
                <a:lnTo>
                  <a:pt x="1924050" y="0"/>
                </a:lnTo>
                <a:lnTo>
                  <a:pt x="0" y="0"/>
                </a:lnTo>
                <a:close/>
              </a:path>
            </a:pathLst>
          </a:custGeom>
          <a:solidFill>
            <a:srgbClr val="64AA00"/>
          </a:solidFill>
        </p:spPr>
        <p:txBody>
          <a:bodyPr wrap="square" lIns="0" tIns="0" rIns="0" bIns="0" rtlCol="0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9" name="object 9">
            <a:extLst>
              <a:ext uri="{FF2B5EF4-FFF2-40B4-BE49-F238E27FC236}">
                <a16:creationId xmlns:a16="http://schemas.microsoft.com/office/drawing/2014/main" id="{8CF8E73E-4688-09F4-7C4E-8D772A0854B8}"/>
              </a:ext>
            </a:extLst>
          </p:cNvPr>
          <p:cNvSpPr txBox="1"/>
          <p:nvPr/>
        </p:nvSpPr>
        <p:spPr>
          <a:xfrm>
            <a:off x="10594085" y="152780"/>
            <a:ext cx="1153795" cy="706755"/>
          </a:xfrm>
          <a:prstGeom prst="rect">
            <a:avLst/>
          </a:prstGeom>
        </p:spPr>
        <p:txBody>
          <a:bodyPr vert="horz" wrap="square" lIns="0" tIns="177800" rIns="0" bIns="0" rtlCol="0">
            <a:spAutoFit/>
          </a:bodyPr>
          <a:lstStyle/>
          <a:p>
            <a:pPr marL="184785" marR="5080" lvl="0" indent="-172720" defTabSz="914400" eaLnBrk="1" fontAlgn="auto" latinLnBrk="0" hangingPunct="1">
              <a:lnSpc>
                <a:spcPct val="61400"/>
              </a:lnSpc>
              <a:spcBef>
                <a:spcPts val="14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sz="2750" b="0" i="0" u="none" strike="noStrike" kern="0" cap="none" spc="-85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Original </a:t>
            </a:r>
            <a:r>
              <a:rPr kumimoji="0" sz="2750" b="0" i="0" u="none" strike="noStrike" kern="0" cap="none" spc="-3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Article</a:t>
            </a:r>
            <a:endParaRPr kumimoji="0" sz="275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10" name="object 10">
            <a:extLst>
              <a:ext uri="{FF2B5EF4-FFF2-40B4-BE49-F238E27FC236}">
                <a16:creationId xmlns:a16="http://schemas.microsoft.com/office/drawing/2014/main" id="{F936A700-B97D-554F-BC90-F82347D17014}"/>
              </a:ext>
            </a:extLst>
          </p:cNvPr>
          <p:cNvSpPr/>
          <p:nvPr/>
        </p:nvSpPr>
        <p:spPr>
          <a:xfrm>
            <a:off x="-1144639" y="5202934"/>
            <a:ext cx="8648615" cy="1676400"/>
          </a:xfrm>
          <a:custGeom>
            <a:avLst/>
            <a:gdLst/>
            <a:ahLst/>
            <a:cxnLst/>
            <a:rect l="l" t="t" r="r" b="b"/>
            <a:pathLst>
              <a:path w="8592185" h="1676400">
                <a:moveTo>
                  <a:pt x="8592079" y="495579"/>
                </a:moveTo>
                <a:lnTo>
                  <a:pt x="1105429" y="495579"/>
                </a:lnTo>
                <a:lnTo>
                  <a:pt x="1105429" y="1676400"/>
                </a:lnTo>
                <a:lnTo>
                  <a:pt x="8589829" y="1676400"/>
                </a:lnTo>
                <a:lnTo>
                  <a:pt x="8592079" y="495579"/>
                </a:lnTo>
                <a:close/>
              </a:path>
              <a:path w="8592185" h="1676400">
                <a:moveTo>
                  <a:pt x="1105429" y="490534"/>
                </a:moveTo>
                <a:lnTo>
                  <a:pt x="0" y="490534"/>
                </a:lnTo>
                <a:lnTo>
                  <a:pt x="3863218" y="495579"/>
                </a:lnTo>
                <a:lnTo>
                  <a:pt x="1105429" y="495579"/>
                </a:lnTo>
                <a:lnTo>
                  <a:pt x="1105429" y="490534"/>
                </a:lnTo>
                <a:close/>
              </a:path>
              <a:path w="8592185" h="1676400">
                <a:moveTo>
                  <a:pt x="1107336" y="0"/>
                </a:moveTo>
                <a:lnTo>
                  <a:pt x="1105518" y="146864"/>
                </a:lnTo>
                <a:lnTo>
                  <a:pt x="1105429" y="490534"/>
                </a:lnTo>
                <a:lnTo>
                  <a:pt x="1499199" y="490534"/>
                </a:lnTo>
                <a:lnTo>
                  <a:pt x="1455389" y="483595"/>
                </a:lnTo>
                <a:lnTo>
                  <a:pt x="1413217" y="471827"/>
                </a:lnTo>
                <a:lnTo>
                  <a:pt x="1372889" y="455496"/>
                </a:lnTo>
                <a:lnTo>
                  <a:pt x="1334608" y="434865"/>
                </a:lnTo>
                <a:lnTo>
                  <a:pt x="1298581" y="410201"/>
                </a:lnTo>
                <a:lnTo>
                  <a:pt x="1265012" y="381768"/>
                </a:lnTo>
                <a:lnTo>
                  <a:pt x="1234106" y="349831"/>
                </a:lnTo>
                <a:lnTo>
                  <a:pt x="1206069" y="314655"/>
                </a:lnTo>
                <a:lnTo>
                  <a:pt x="1181104" y="276505"/>
                </a:lnTo>
                <a:lnTo>
                  <a:pt x="1159418" y="235647"/>
                </a:lnTo>
                <a:lnTo>
                  <a:pt x="1141215" y="192345"/>
                </a:lnTo>
                <a:lnTo>
                  <a:pt x="1126701" y="146864"/>
                </a:lnTo>
                <a:lnTo>
                  <a:pt x="1116079" y="99469"/>
                </a:lnTo>
                <a:lnTo>
                  <a:pt x="1109556" y="50426"/>
                </a:lnTo>
                <a:lnTo>
                  <a:pt x="1107336" y="0"/>
                </a:lnTo>
                <a:close/>
              </a:path>
            </a:pathLst>
          </a:custGeom>
          <a:solidFill>
            <a:srgbClr val="0092F7"/>
          </a:solidFill>
        </p:spPr>
        <p:txBody>
          <a:bodyPr wrap="square" lIns="0" tIns="0" rIns="0" bIns="0" rtlCol="0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11" name="object 11">
            <a:extLst>
              <a:ext uri="{FF2B5EF4-FFF2-40B4-BE49-F238E27FC236}">
                <a16:creationId xmlns:a16="http://schemas.microsoft.com/office/drawing/2014/main" id="{018FFD08-E3A9-4F51-9731-02BAE216BDED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294957" y="79374"/>
            <a:ext cx="9687243" cy="899605"/>
          </a:xfrm>
          <a:prstGeom prst="rect">
            <a:avLst/>
          </a:prstGeom>
        </p:spPr>
        <p:txBody>
          <a:bodyPr vert="horz" wrap="square" lIns="0" tIns="52705" rIns="0" bIns="0" rtlCol="0">
            <a:spAutoFit/>
          </a:bodyPr>
          <a:lstStyle/>
          <a:p>
            <a:r>
              <a:rPr lang="en-US" b="1" dirty="0"/>
              <a:t>Serum renin levels refine acute kidney injury prediction in critically ill children </a:t>
            </a:r>
            <a:endParaRPr lang="en-IL" dirty="0"/>
          </a:p>
        </p:txBody>
      </p:sp>
      <p:sp>
        <p:nvSpPr>
          <p:cNvPr id="16" name="object 16">
            <a:extLst>
              <a:ext uri="{FF2B5EF4-FFF2-40B4-BE49-F238E27FC236}">
                <a16:creationId xmlns:a16="http://schemas.microsoft.com/office/drawing/2014/main" id="{33231585-6CE0-7438-3AC6-17B451290FBF}"/>
              </a:ext>
            </a:extLst>
          </p:cNvPr>
          <p:cNvSpPr txBox="1"/>
          <p:nvPr/>
        </p:nvSpPr>
        <p:spPr>
          <a:xfrm>
            <a:off x="8301282" y="6631863"/>
            <a:ext cx="3115310" cy="19621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0" lvl="0" indent="0" defTabSz="914400" eaLnBrk="1" fontAlgn="auto" latinLnBrk="0" hangingPunct="1">
              <a:lnSpc>
                <a:spcPts val="143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International</a:t>
            </a:r>
            <a:r>
              <a:rPr kumimoji="0" sz="1200" b="0" i="0" u="none" strike="noStrike" kern="0" cap="none" spc="-3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Pediatric</a:t>
            </a:r>
            <a:r>
              <a:rPr kumimoji="0" sz="1200" b="0" i="0" u="none" strike="noStrike" kern="0" cap="none" spc="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Nephrology</a:t>
            </a:r>
            <a:r>
              <a:rPr kumimoji="0" sz="1200" b="0" i="0" u="none" strike="noStrike" kern="0" cap="none" spc="-6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1200" b="0" i="0" u="none" strike="noStrike" kern="0" cap="none" spc="-1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rPr>
              <a:t>Association</a:t>
            </a:r>
            <a:endParaRPr kumimoji="0" sz="12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12" name="object 12">
            <a:extLst>
              <a:ext uri="{FF2B5EF4-FFF2-40B4-BE49-F238E27FC236}">
                <a16:creationId xmlns:a16="http://schemas.microsoft.com/office/drawing/2014/main" id="{784E7B6E-CFE5-5687-BEF6-C35E6E61FDAA}"/>
              </a:ext>
            </a:extLst>
          </p:cNvPr>
          <p:cNvSpPr txBox="1"/>
          <p:nvPr/>
        </p:nvSpPr>
        <p:spPr>
          <a:xfrm>
            <a:off x="315123" y="1190377"/>
            <a:ext cx="11939588" cy="3052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9050" marR="0" lvl="0" indent="0" defTabSz="914400" eaLnBrk="1" fontAlgn="auto" latinLnBrk="0" hangingPunct="1">
              <a:lnSpc>
                <a:spcPct val="100000"/>
              </a:lnSpc>
              <a:spcBef>
                <a:spcPts val="1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sz="1900" b="1" i="0" u="none" strike="noStrike" kern="0" cap="none" spc="-55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AIM</a:t>
            </a:r>
            <a:r>
              <a:rPr kumimoji="0" sz="1900" b="0" i="0" u="none" strike="noStrike" kern="0" cap="none" spc="-55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:</a:t>
            </a:r>
            <a:r>
              <a:rPr kumimoji="0" sz="1900" b="0" i="0" u="none" strike="noStrike" kern="0" cap="none" spc="-75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lang="en-US" sz="1900" b="0" i="0" u="none" strike="noStrike" kern="0" cap="none" spc="-45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To evaluate whether serum renin enhances acute kidney injury (AKI) risk stratification in critically ill children</a:t>
            </a:r>
          </a:p>
        </p:txBody>
      </p:sp>
      <p:sp>
        <p:nvSpPr>
          <p:cNvPr id="13" name="object 13">
            <a:extLst>
              <a:ext uri="{FF2B5EF4-FFF2-40B4-BE49-F238E27FC236}">
                <a16:creationId xmlns:a16="http://schemas.microsoft.com/office/drawing/2014/main" id="{D6F0EA4C-D00D-6908-2F1F-BBED443C06B8}"/>
              </a:ext>
            </a:extLst>
          </p:cNvPr>
          <p:cNvSpPr txBox="1"/>
          <p:nvPr/>
        </p:nvSpPr>
        <p:spPr>
          <a:xfrm>
            <a:off x="7735914" y="5719049"/>
            <a:ext cx="3401060" cy="3346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 marR="0" lvl="0" indent="0" defTabSz="914400" eaLnBrk="1" fontAlgn="auto" latinLnBrk="0" hangingPunct="1">
              <a:lnSpc>
                <a:spcPct val="100000"/>
              </a:lnSpc>
              <a:spcBef>
                <a:spcPts val="125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IL" sz="2000" b="0" i="0" u="none" strike="noStrike" kern="0" cap="none" spc="-9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Pode Shakked</a:t>
            </a:r>
            <a:r>
              <a:rPr kumimoji="0" lang="en-IL" sz="2000" b="0" i="0" u="none" strike="noStrike" kern="0" cap="none" spc="-11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20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et</a:t>
            </a:r>
            <a:r>
              <a:rPr kumimoji="0" sz="2000" b="0" i="0" u="none" strike="noStrike" kern="0" cap="none" spc="-8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2000" b="0" i="0" u="none" strike="noStrike" kern="0" cap="none" spc="-10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al.</a:t>
            </a:r>
            <a:r>
              <a:rPr kumimoji="0" sz="2000" b="0" i="0" u="none" strike="noStrike" kern="0" cap="none" spc="-13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sz="2000" b="0" i="0" u="none" strike="noStrike" kern="0" cap="none" spc="-6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2024</a:t>
            </a:r>
            <a:endParaRPr kumimoji="0" sz="20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14" name="object 14">
            <a:extLst>
              <a:ext uri="{FF2B5EF4-FFF2-40B4-BE49-F238E27FC236}">
                <a16:creationId xmlns:a16="http://schemas.microsoft.com/office/drawing/2014/main" id="{D7B05023-04D0-6695-56F4-ED6865D20944}"/>
              </a:ext>
            </a:extLst>
          </p:cNvPr>
          <p:cNvSpPr txBox="1"/>
          <p:nvPr/>
        </p:nvSpPr>
        <p:spPr>
          <a:xfrm>
            <a:off x="145741" y="5818583"/>
            <a:ext cx="7270368" cy="832792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 lvl="0" indent="0" defTabSz="914400" eaLnBrk="1" fontAlgn="auto" latinLnBrk="0" hangingPunct="1">
              <a:lnSpc>
                <a:spcPct val="100800"/>
              </a:lnSpc>
              <a:spcBef>
                <a:spcPts val="85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sz="1800" b="1" u="none" strike="noStrike" kern="0" cap="none" spc="-210" normalizeH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cs typeface="Arial"/>
              </a:rPr>
              <a:t>CONCLUSION:</a:t>
            </a:r>
            <a:r>
              <a:rPr kumimoji="0" sz="1800" b="1" u="none" strike="noStrike" kern="0" cap="none" spc="-65" normalizeH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Arial"/>
              </a:rPr>
              <a:t> </a:t>
            </a:r>
            <a:r>
              <a:rPr kumimoji="0" lang="en-US" sz="1800" b="0" i="0" u="none" strike="noStrike" kern="0" cap="none" spc="-65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Arial"/>
              </a:rPr>
              <a:t>Serum renin progressively increases across </a:t>
            </a:r>
            <a:r>
              <a:rPr kumimoji="0" lang="en-US" sz="1800" b="0" i="0" u="none" strike="noStrike" kern="0" cap="none" spc="-65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Arial"/>
              </a:rPr>
              <a:t>sAKI</a:t>
            </a:r>
            <a:r>
              <a:rPr kumimoji="0" lang="en-US" sz="1800" b="0" i="0" u="none" strike="noStrike" kern="0" cap="none" spc="-65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Arial"/>
              </a:rPr>
              <a:t> risk strata and enhances specificity and PPV of existing prediction algorithms in critically ill children</a:t>
            </a:r>
            <a:endParaRPr kumimoji="0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AAF500D-37FB-906E-076E-576969846BBB}"/>
              </a:ext>
            </a:extLst>
          </p:cNvPr>
          <p:cNvSpPr txBox="1"/>
          <p:nvPr/>
        </p:nvSpPr>
        <p:spPr>
          <a:xfrm>
            <a:off x="227525" y="1632506"/>
            <a:ext cx="45730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SIGN &amp; OUTCOMES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						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4A8A358-CD32-A4CD-187F-82531DD669A7}"/>
              </a:ext>
            </a:extLst>
          </p:cNvPr>
          <p:cNvSpPr txBox="1"/>
          <p:nvPr/>
        </p:nvSpPr>
        <p:spPr>
          <a:xfrm>
            <a:off x="-130285" y="1958395"/>
            <a:ext cx="5160587" cy="37702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b="1" kern="1200" dirty="0">
                <a:solidFill>
                  <a:srgbClr val="4472C4">
                    <a:lumMod val="75000"/>
                  </a:srgbClr>
                </a:solidFill>
                <a:latin typeface="Calibri" panose="020F0502020204030204"/>
              </a:rPr>
              <a:t>Observational p</a:t>
            </a:r>
            <a:r>
              <a:rPr kumimoji="0" lang="en-GB" sz="1600" b="1" i="0" u="none" strike="noStrike" kern="1200" cap="none" spc="0" normalizeH="0" baseline="0" noProof="0" dirty="0" err="1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ilot</a:t>
            </a:r>
            <a:r>
              <a:rPr kumimoji="0" lang="en-GB" sz="1600" b="1" i="0" u="none" strike="noStrike" kern="1200" cap="none" spc="0" normalizeH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 </a:t>
            </a: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study 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of PICU patients from the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TAKING FOCUS 2 (TF2) study of standardized</a:t>
            </a:r>
            <a:r>
              <a:rPr kumimoji="0" lang="en-GB" sz="1600" b="0" i="0" u="none" strike="noStrike" kern="1200" cap="none" spc="0" normalizeH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 AKI risk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kern="1200" baseline="0" dirty="0">
                <a:solidFill>
                  <a:srgbClr val="4472C4">
                    <a:lumMod val="75000"/>
                  </a:srgbClr>
                </a:solidFill>
                <a:latin typeface="Calibri" panose="020F0502020204030204"/>
              </a:rPr>
              <a:t>Stratification</a:t>
            </a:r>
            <a:r>
              <a:rPr lang="en-GB" sz="1600" kern="1200" dirty="0">
                <a:solidFill>
                  <a:srgbClr val="4472C4">
                    <a:lumMod val="75000"/>
                  </a:srgbClr>
                </a:solidFill>
                <a:latin typeface="Calibri" panose="020F0502020204030204"/>
              </a:rPr>
              <a:t> with the Renal Angina Index (RAI) and urine neutrophil gelatinase-associated lipocalin (</a:t>
            </a:r>
            <a:r>
              <a:rPr lang="en-GB" sz="1600" kern="1200" dirty="0" err="1">
                <a:solidFill>
                  <a:srgbClr val="4472C4">
                    <a:lumMod val="75000"/>
                  </a:srgbClr>
                </a:solidFill>
                <a:latin typeface="Calibri" panose="020F0502020204030204"/>
              </a:rPr>
              <a:t>uNGAL</a:t>
            </a:r>
            <a:r>
              <a:rPr lang="en-GB" sz="1600" kern="1200" dirty="0">
                <a:solidFill>
                  <a:srgbClr val="4472C4">
                    <a:lumMod val="75000"/>
                  </a:srgbClr>
                </a:solidFill>
                <a:latin typeface="Calibri" panose="020F0502020204030204"/>
              </a:rPr>
              <a:t>)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srgbClr val="4472C4">
                  <a:lumMod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srgbClr val="4472C4">
                  <a:lumMod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srgbClr val="4472C4">
                  <a:lumMod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                 107 children included in the final analyses</a:t>
            </a: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srgbClr val="4472C4">
                  <a:lumMod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rect serum renin levels 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ere </a:t>
            </a:r>
            <a:r>
              <a:rPr kumimoji="0" lang="en-GB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alyzed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cross  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F2 risk stratification algorithm branchpoints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   </a:t>
            </a:r>
            <a:r>
              <a:rPr kumimoji="0" lang="en-GB" sz="1600" i="0" u="sng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</a:rPr>
              <a:t>Primary outcome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lang="en-GB" sz="1600" b="1" kern="1200" noProof="0" dirty="0">
                <a:solidFill>
                  <a:srgbClr val="4472C4">
                    <a:lumMod val="75000"/>
                  </a:srgbClr>
                </a:solidFill>
                <a:latin typeface="Calibri" panose="020F0502020204030204"/>
                <a:ea typeface="+mn-ea"/>
                <a:cs typeface="+mn-cs"/>
              </a:rPr>
              <a:t>Severe </a:t>
            </a: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KI at day 2-4 (</a:t>
            </a:r>
            <a:r>
              <a:rPr kumimoji="0" lang="en-GB" sz="1600" b="1" i="0" u="none" strike="noStrike" kern="1200" cap="none" spc="0" normalizeH="0" baseline="0" noProof="0" dirty="0" err="1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AKI</a:t>
            </a: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of PICU admission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</a:t>
            </a:r>
            <a:r>
              <a:rPr kumimoji="0" lang="en-GB" sz="1600" i="0" u="sng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condary outcomes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eed for CKRT 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 the first week, PICU </a:t>
            </a: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ortality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, and PICU </a:t>
            </a: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ngth of stay 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 survivors  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B9704A3-8E68-280B-0DBA-CC34906AC02E}"/>
              </a:ext>
            </a:extLst>
          </p:cNvPr>
          <p:cNvCxnSpPr>
            <a:cxnSpLocks/>
          </p:cNvCxnSpPr>
          <p:nvPr/>
        </p:nvCxnSpPr>
        <p:spPr>
          <a:xfrm>
            <a:off x="3657600" y="3326035"/>
            <a:ext cx="760938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6F19B65C-4491-9D4A-F38F-7C2C4DFFDDA0}"/>
              </a:ext>
            </a:extLst>
          </p:cNvPr>
          <p:cNvSpPr txBox="1"/>
          <p:nvPr/>
        </p:nvSpPr>
        <p:spPr>
          <a:xfrm>
            <a:off x="5023674" y="1617932"/>
            <a:ext cx="65055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srgbClr val="4472C4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EY FINDINGS:</a:t>
            </a:r>
            <a:endParaRPr kumimoji="0" lang="en-IL" sz="1800" b="0" i="0" u="none" strike="noStrike" kern="1200" cap="none" spc="0" normalizeH="0" baseline="0" noProof="0" dirty="0">
              <a:ln>
                <a:noFill/>
              </a:ln>
              <a:solidFill>
                <a:srgbClr val="4472C4">
                  <a:lumMod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6CB4DF25-3871-41F4-5722-A94AE40BC677}"/>
              </a:ext>
            </a:extLst>
          </p:cNvPr>
          <p:cNvSpPr/>
          <p:nvPr/>
        </p:nvSpPr>
        <p:spPr>
          <a:xfrm>
            <a:off x="5114094" y="4435733"/>
            <a:ext cx="6988262" cy="1066959"/>
          </a:xfrm>
          <a:prstGeom prst="rect">
            <a:avLst/>
          </a:prstGeom>
          <a:noFill/>
          <a:ln w="41275">
            <a:solidFill>
              <a:schemeClr val="tx2">
                <a:lumMod val="75000"/>
              </a:scheme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rtlCol="0" anchor="ctr">
            <a:spAutoFit/>
          </a:bodyPr>
          <a:lstStyle/>
          <a:p>
            <a:pPr algn="l" rtl="0">
              <a:spcAft>
                <a:spcPts val="200"/>
              </a:spcAft>
              <a:defRPr/>
            </a:pPr>
            <a:r>
              <a:rPr lang="en-GB" sz="1200" kern="1200" dirty="0">
                <a:solidFill>
                  <a:schemeClr val="tx2">
                    <a:lumMod val="75000"/>
                  </a:schemeClr>
                </a:solidFill>
              </a:rPr>
              <a:t>- </a:t>
            </a:r>
            <a:r>
              <a:rPr lang="en-GB" sz="1200" b="1" kern="1200" dirty="0">
                <a:solidFill>
                  <a:schemeClr val="tx2">
                    <a:lumMod val="75000"/>
                  </a:schemeClr>
                </a:solidFill>
              </a:rPr>
              <a:t>Patients with </a:t>
            </a:r>
            <a:r>
              <a:rPr lang="en-GB" sz="1200" b="1" kern="1200" dirty="0" err="1">
                <a:solidFill>
                  <a:schemeClr val="tx2">
                    <a:lumMod val="75000"/>
                  </a:schemeClr>
                </a:solidFill>
              </a:rPr>
              <a:t>sAKI</a:t>
            </a:r>
            <a:r>
              <a:rPr lang="en-GB" sz="1200" b="1" kern="1200" dirty="0">
                <a:solidFill>
                  <a:schemeClr val="tx2">
                    <a:lumMod val="75000"/>
                  </a:schemeClr>
                </a:solidFill>
              </a:rPr>
              <a:t> had higher renin concentrations </a:t>
            </a:r>
            <a:r>
              <a:rPr lang="en-GB" sz="1200" kern="1200" dirty="0">
                <a:solidFill>
                  <a:schemeClr val="tx2">
                    <a:lumMod val="75000"/>
                  </a:schemeClr>
                </a:solidFill>
              </a:rPr>
              <a:t>(102 [35.2-374] vs. 41.6 [11.4-111] </a:t>
            </a:r>
            <a:r>
              <a:rPr lang="en-GB" sz="1200" kern="1200" dirty="0" err="1">
                <a:solidFill>
                  <a:schemeClr val="tx2">
                    <a:lumMod val="75000"/>
                  </a:schemeClr>
                </a:solidFill>
              </a:rPr>
              <a:t>pg</a:t>
            </a:r>
            <a:r>
              <a:rPr lang="en-GB" sz="1200" kern="1200" dirty="0">
                <a:solidFill>
                  <a:schemeClr val="tx2">
                    <a:lumMod val="75000"/>
                  </a:schemeClr>
                </a:solidFill>
              </a:rPr>
              <a:t>/mL, p=0.002), a difference that remained significant after adjustment for covariates (p=0.001). </a:t>
            </a:r>
          </a:p>
          <a:p>
            <a:pPr algn="l" rtl="0">
              <a:spcAft>
                <a:spcPts val="200"/>
              </a:spcAft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-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Patients with renin ≥100 </a:t>
            </a: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pg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/mL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 had</a:t>
            </a:r>
            <a:r>
              <a:rPr kumimoji="0" lang="he-IL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  <a:cs typeface="Arial" panose="020B0604020202020204" pitchFamily="34" charset="0"/>
              </a:rPr>
              <a:t>: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H</a:t>
            </a: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igher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 </a:t>
            </a: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sAKI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 rates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(54% vs. 32%, p=0.03) and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increased </a:t>
            </a:r>
            <a:r>
              <a:rPr kumimoji="0" lang="he-IL" sz="1200" b="1" i="0" u="none" strike="noStrike" kern="1200" cap="none" spc="0" normalizeH="0" baseline="0" noProof="0" dirty="0" err="1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/>
                <a:cs typeface="Arial" panose="020B0604020202020204" pitchFamily="34" charset="0"/>
              </a:rPr>
              <a:t>mortality</a:t>
            </a:r>
            <a:r>
              <a:rPr kumimoji="0" lang="he-IL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  <a:cs typeface="Arial" panose="020B0604020202020204" pitchFamily="34" charset="0"/>
              </a:rPr>
              <a:t>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/>
              </a:rPr>
              <a:t>(36% vs. 12%, p=0.004)</a:t>
            </a:r>
            <a:endParaRPr kumimoji="0" lang="he-IL" sz="1200" b="0" i="0" u="none" strike="noStrike" kern="1200" cap="none" spc="0" normalizeH="0" baseline="0" noProof="0" dirty="0">
              <a:ln>
                <a:noFill/>
              </a:ln>
              <a:solidFill>
                <a:schemeClr val="tx2">
                  <a:lumMod val="75000"/>
                </a:schemeClr>
              </a:solidFill>
              <a:effectLst/>
              <a:uLnTx/>
              <a:uFillTx/>
              <a:latin typeface="Calibri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-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Adding renin ≥100 </a:t>
            </a: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pg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/mL to RAI+/</a:t>
            </a: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uNGAL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+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improved specificity and</a:t>
            </a:r>
            <a:r>
              <a:rPr kumimoji="0" lang="en-GB" sz="1200" b="0" i="0" u="none" strike="noStrike" kern="1200" cap="none" spc="0" normalizeH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 PPV of </a:t>
            </a:r>
            <a:r>
              <a:rPr kumimoji="0" lang="en-GB" sz="1200" b="0" i="0" u="none" strike="noStrike" kern="1200" cap="none" spc="0" normalizeH="0" baseline="0" noProof="0" dirty="0" err="1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sAKI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75000"/>
                  </a:schemeClr>
                </a:solidFill>
                <a:effectLst/>
                <a:uLnTx/>
                <a:uFillTx/>
                <a:latin typeface="Calibri" panose="020F0502020204030204"/>
              </a:rPr>
              <a:t> prediction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44CCBFE9-6E19-FBA6-A825-F0D36286024D}"/>
              </a:ext>
            </a:extLst>
          </p:cNvPr>
          <p:cNvGrpSpPr/>
          <p:nvPr/>
        </p:nvGrpSpPr>
        <p:grpSpPr>
          <a:xfrm>
            <a:off x="1810569" y="3021853"/>
            <a:ext cx="770138" cy="648224"/>
            <a:chOff x="1752600" y="2632505"/>
            <a:chExt cx="944142" cy="863706"/>
          </a:xfrm>
        </p:grpSpPr>
        <p:sp>
          <p:nvSpPr>
            <p:cNvPr id="25" name="Freeform: Shape 46">
              <a:extLst>
                <a:ext uri="{FF2B5EF4-FFF2-40B4-BE49-F238E27FC236}">
                  <a16:creationId xmlns:a16="http://schemas.microsoft.com/office/drawing/2014/main" id="{65E97167-1761-CE14-0C9B-1CA1E97A53BE}"/>
                </a:ext>
              </a:extLst>
            </p:cNvPr>
            <p:cNvSpPr/>
            <p:nvPr/>
          </p:nvSpPr>
          <p:spPr>
            <a:xfrm>
              <a:off x="2274485" y="2632505"/>
              <a:ext cx="422257" cy="863706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chemeClr val="tx2">
                <a:lumMod val="60000"/>
                <a:lumOff val="40000"/>
              </a:schemeClr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8A4E0CAA-2375-CE19-9C3C-B46E9A8A20EB}"/>
                </a:ext>
              </a:extLst>
            </p:cNvPr>
            <p:cNvGrpSpPr/>
            <p:nvPr/>
          </p:nvGrpSpPr>
          <p:grpSpPr>
            <a:xfrm>
              <a:off x="1752600" y="2632505"/>
              <a:ext cx="422257" cy="863706"/>
              <a:chOff x="1979496" y="2632505"/>
              <a:chExt cx="422257" cy="863706"/>
            </a:xfrm>
            <a:solidFill>
              <a:srgbClr val="7030A0"/>
            </a:solidFill>
          </p:grpSpPr>
          <p:sp>
            <p:nvSpPr>
              <p:cNvPr id="20" name="Freeform: Shape 46">
                <a:extLst>
                  <a:ext uri="{FF2B5EF4-FFF2-40B4-BE49-F238E27FC236}">
                    <a16:creationId xmlns:a16="http://schemas.microsoft.com/office/drawing/2014/main" id="{D45BD9AA-43B5-ACC8-A6E2-1B1C177CB059}"/>
                  </a:ext>
                </a:extLst>
              </p:cNvPr>
              <p:cNvSpPr/>
              <p:nvPr/>
            </p:nvSpPr>
            <p:spPr>
              <a:xfrm>
                <a:off x="1979496" y="2632505"/>
                <a:ext cx="422257" cy="863706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grpFill/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99" name="Triangle 98">
                <a:extLst>
                  <a:ext uri="{FF2B5EF4-FFF2-40B4-BE49-F238E27FC236}">
                    <a16:creationId xmlns:a16="http://schemas.microsoft.com/office/drawing/2014/main" id="{607A5295-F86B-A001-54E8-B2C2347B3DE8}"/>
                  </a:ext>
                </a:extLst>
              </p:cNvPr>
              <p:cNvSpPr/>
              <p:nvPr/>
            </p:nvSpPr>
            <p:spPr>
              <a:xfrm>
                <a:off x="2009726" y="2931282"/>
                <a:ext cx="361796" cy="361996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L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B1A8D48D-04F9-A637-2B0B-8291A901788A}"/>
              </a:ext>
            </a:extLst>
          </p:cNvPr>
          <p:cNvGrpSpPr/>
          <p:nvPr/>
        </p:nvGrpSpPr>
        <p:grpSpPr>
          <a:xfrm>
            <a:off x="5086385" y="1905000"/>
            <a:ext cx="7270913" cy="2395330"/>
            <a:chOff x="4675392" y="1992527"/>
            <a:chExt cx="7270913" cy="2395330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BE2DBD3A-52D7-D084-0191-13D8DC8802E0}"/>
                </a:ext>
              </a:extLst>
            </p:cNvPr>
            <p:cNvSpPr/>
            <p:nvPr/>
          </p:nvSpPr>
          <p:spPr>
            <a:xfrm>
              <a:off x="4703101" y="2029429"/>
              <a:ext cx="6988262" cy="2339873"/>
            </a:xfrm>
            <a:prstGeom prst="rect">
              <a:avLst/>
            </a:prstGeom>
            <a:noFill/>
            <a:ln w="41275">
              <a:solidFill>
                <a:srgbClr val="A10068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srgbClr val="00437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6229EC3-7913-1FF1-9A7D-81A8956E67F3}"/>
                </a:ext>
              </a:extLst>
            </p:cNvPr>
            <p:cNvSpPr txBox="1"/>
            <p:nvPr/>
          </p:nvSpPr>
          <p:spPr>
            <a:xfrm>
              <a:off x="4675392" y="1992527"/>
              <a:ext cx="6668218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rtl="0"/>
              <a:r>
                <a:rPr lang="en-US" sz="1600" b="1" dirty="0"/>
                <a:t>Renin Concentrations Along TF2 Branchpoints</a:t>
              </a:r>
              <a:endParaRPr lang="en-IL" sz="1600" b="1" dirty="0"/>
            </a:p>
          </p:txBody>
        </p: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BD30F8D5-93E4-B2E1-468E-3BE1BF14DAD4}"/>
                </a:ext>
              </a:extLst>
            </p:cNvPr>
            <p:cNvGrpSpPr/>
            <p:nvPr/>
          </p:nvGrpSpPr>
          <p:grpSpPr>
            <a:xfrm>
              <a:off x="5026132" y="2066008"/>
              <a:ext cx="6920173" cy="2321849"/>
              <a:chOff x="5026132" y="2066008"/>
              <a:chExt cx="6920173" cy="2321849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991566AF-44F6-F9B3-8A6F-A3130513B801}"/>
                  </a:ext>
                </a:extLst>
              </p:cNvPr>
              <p:cNvGrpSpPr/>
              <p:nvPr/>
            </p:nvGrpSpPr>
            <p:grpSpPr>
              <a:xfrm>
                <a:off x="5026132" y="2066008"/>
                <a:ext cx="6920173" cy="2146389"/>
                <a:chOff x="74970" y="2912136"/>
                <a:chExt cx="6920173" cy="2146389"/>
              </a:xfrm>
            </p:grpSpPr>
            <p:grpSp>
              <p:nvGrpSpPr>
                <p:cNvPr id="33" name="Group 32">
                  <a:extLst>
                    <a:ext uri="{FF2B5EF4-FFF2-40B4-BE49-F238E27FC236}">
                      <a16:creationId xmlns:a16="http://schemas.microsoft.com/office/drawing/2014/main" id="{0072D16B-4B39-6F0F-FACC-760EE35F033C}"/>
                    </a:ext>
                  </a:extLst>
                </p:cNvPr>
                <p:cNvGrpSpPr/>
                <p:nvPr/>
              </p:nvGrpSpPr>
              <p:grpSpPr>
                <a:xfrm>
                  <a:off x="74970" y="2912136"/>
                  <a:ext cx="5674610" cy="2146389"/>
                  <a:chOff x="803333" y="2288617"/>
                  <a:chExt cx="7951821" cy="3180299"/>
                </a:xfrm>
              </p:grpSpPr>
              <p:pic>
                <p:nvPicPr>
                  <p:cNvPr id="37" name="Image 1" descr="preencoded.png">
                    <a:extLst>
                      <a:ext uri="{FF2B5EF4-FFF2-40B4-BE49-F238E27FC236}">
                        <a16:creationId xmlns:a16="http://schemas.microsoft.com/office/drawing/2014/main" id="{8BC1C40A-FFE8-6355-2DEC-4465FC4531D8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1"/>
                    </p:custDataLst>
                  </p:nvPr>
                </p:nvPicPr>
                <p:blipFill>
                  <a:blip r:embed="rId19"/>
                  <a:stretch>
                    <a:fillRect/>
                  </a:stretch>
                </p:blipFill>
                <p:spPr>
                  <a:xfrm>
                    <a:off x="1821940" y="4022754"/>
                    <a:ext cx="1234440" cy="173736"/>
                  </a:xfrm>
                  <a:prstGeom prst="rect">
                    <a:avLst/>
                  </a:prstGeom>
                </p:spPr>
              </p:pic>
              <p:pic>
                <p:nvPicPr>
                  <p:cNvPr id="38" name="Image 2" descr="preencoded.png">
                    <a:extLst>
                      <a:ext uri="{FF2B5EF4-FFF2-40B4-BE49-F238E27FC236}">
                        <a16:creationId xmlns:a16="http://schemas.microsoft.com/office/drawing/2014/main" id="{B86532F4-9330-BAE0-4AFF-4FF4498308E6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2"/>
                    </p:custDataLst>
                  </p:nvPr>
                </p:nvPicPr>
                <p:blipFill>
                  <a:blip r:embed="rId20"/>
                  <a:stretch>
                    <a:fillRect/>
                  </a:stretch>
                </p:blipFill>
                <p:spPr>
                  <a:xfrm>
                    <a:off x="2187544" y="4024184"/>
                    <a:ext cx="905256" cy="1133856"/>
                  </a:xfrm>
                  <a:prstGeom prst="rect">
                    <a:avLst/>
                  </a:prstGeom>
                </p:spPr>
              </p:pic>
              <p:pic>
                <p:nvPicPr>
                  <p:cNvPr id="39" name="Image 3" descr="preencoded.png">
                    <a:extLst>
                      <a:ext uri="{FF2B5EF4-FFF2-40B4-BE49-F238E27FC236}">
                        <a16:creationId xmlns:a16="http://schemas.microsoft.com/office/drawing/2014/main" id="{E3BA90B3-1BCD-B96C-6FDB-A8C83B3A7E3F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3"/>
                    </p:custDataLst>
                  </p:nvPr>
                </p:nvPicPr>
                <p:blipFill>
                  <a:blip r:embed="rId21"/>
                  <a:stretch>
                    <a:fillRect/>
                  </a:stretch>
                </p:blipFill>
                <p:spPr>
                  <a:xfrm>
                    <a:off x="2903749" y="3798319"/>
                    <a:ext cx="1371600" cy="612648"/>
                  </a:xfrm>
                  <a:prstGeom prst="rect">
                    <a:avLst/>
                  </a:prstGeom>
                </p:spPr>
              </p:pic>
              <p:pic>
                <p:nvPicPr>
                  <p:cNvPr id="40" name="Image 4" descr="preencoded.png">
                    <a:extLst>
                      <a:ext uri="{FF2B5EF4-FFF2-40B4-BE49-F238E27FC236}">
                        <a16:creationId xmlns:a16="http://schemas.microsoft.com/office/drawing/2014/main" id="{B69617B0-F74B-E5F7-D102-7A4D36807354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4"/>
                    </p:custDataLst>
                  </p:nvPr>
                </p:nvPicPr>
                <p:blipFill>
                  <a:blip r:embed="rId22"/>
                  <a:stretch>
                    <a:fillRect/>
                  </a:stretch>
                </p:blipFill>
                <p:spPr>
                  <a:xfrm>
                    <a:off x="7371982" y="4400518"/>
                    <a:ext cx="1371600" cy="941832"/>
                  </a:xfrm>
                  <a:prstGeom prst="rect">
                    <a:avLst/>
                  </a:prstGeom>
                </p:spPr>
              </p:pic>
              <p:pic>
                <p:nvPicPr>
                  <p:cNvPr id="41" name="Image 5" descr="preencoded.png">
                    <a:extLst>
                      <a:ext uri="{FF2B5EF4-FFF2-40B4-BE49-F238E27FC236}">
                        <a16:creationId xmlns:a16="http://schemas.microsoft.com/office/drawing/2014/main" id="{2AF5F791-73D5-1D8D-0C7C-742A668D2647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5"/>
                    </p:custDataLst>
                  </p:nvPr>
                </p:nvPicPr>
                <p:blipFill>
                  <a:blip r:embed="rId23"/>
                  <a:stretch>
                    <a:fillRect/>
                  </a:stretch>
                </p:blipFill>
                <p:spPr>
                  <a:xfrm>
                    <a:off x="7383554" y="2288617"/>
                    <a:ext cx="1371600" cy="749808"/>
                  </a:xfrm>
                  <a:prstGeom prst="rect">
                    <a:avLst/>
                  </a:prstGeom>
                </p:spPr>
              </p:pic>
              <p:pic>
                <p:nvPicPr>
                  <p:cNvPr id="42" name="Image 6" descr="preencoded.png">
                    <a:extLst>
                      <a:ext uri="{FF2B5EF4-FFF2-40B4-BE49-F238E27FC236}">
                        <a16:creationId xmlns:a16="http://schemas.microsoft.com/office/drawing/2014/main" id="{F2D4FA4C-8571-7403-18F9-021FDCE21D31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6"/>
                    </p:custDataLst>
                  </p:nvPr>
                </p:nvPicPr>
                <p:blipFill>
                  <a:blip r:embed="rId24"/>
                  <a:stretch>
                    <a:fillRect/>
                  </a:stretch>
                </p:blipFill>
                <p:spPr>
                  <a:xfrm>
                    <a:off x="5483778" y="2841861"/>
                    <a:ext cx="1371600" cy="612648"/>
                  </a:xfrm>
                  <a:prstGeom prst="rect">
                    <a:avLst/>
                  </a:prstGeom>
                </p:spPr>
              </p:pic>
              <p:pic>
                <p:nvPicPr>
                  <p:cNvPr id="43" name="Image 7" descr="preencoded.png">
                    <a:extLst>
                      <a:ext uri="{FF2B5EF4-FFF2-40B4-BE49-F238E27FC236}">
                        <a16:creationId xmlns:a16="http://schemas.microsoft.com/office/drawing/2014/main" id="{F994F1B4-3E1D-B83A-091E-D547AC7C4A31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7"/>
                    </p:custDataLst>
                  </p:nvPr>
                </p:nvPicPr>
                <p:blipFill>
                  <a:blip r:embed="rId25"/>
                  <a:stretch>
                    <a:fillRect/>
                  </a:stretch>
                </p:blipFill>
                <p:spPr>
                  <a:xfrm>
                    <a:off x="4101864" y="3055696"/>
                    <a:ext cx="1533144" cy="2115312"/>
                  </a:xfrm>
                  <a:prstGeom prst="rect">
                    <a:avLst/>
                  </a:prstGeom>
                </p:spPr>
              </p:pic>
              <p:pic>
                <p:nvPicPr>
                  <p:cNvPr id="44" name="Image 8" descr="preencoded.png">
                    <a:extLst>
                      <a:ext uri="{FF2B5EF4-FFF2-40B4-BE49-F238E27FC236}">
                        <a16:creationId xmlns:a16="http://schemas.microsoft.com/office/drawing/2014/main" id="{8C9DEFC0-27CF-C4A0-CCE9-8DDECB3A01CB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8"/>
                    </p:custDataLst>
                  </p:nvPr>
                </p:nvPicPr>
                <p:blipFill>
                  <a:blip r:embed="rId26"/>
                  <a:stretch>
                    <a:fillRect/>
                  </a:stretch>
                </p:blipFill>
                <p:spPr>
                  <a:xfrm>
                    <a:off x="2916041" y="4527084"/>
                    <a:ext cx="1371600" cy="941832"/>
                  </a:xfrm>
                  <a:prstGeom prst="rect">
                    <a:avLst/>
                  </a:prstGeom>
                </p:spPr>
              </p:pic>
              <p:pic>
                <p:nvPicPr>
                  <p:cNvPr id="45" name="Image 9" descr="preencoded.png">
                    <a:extLst>
                      <a:ext uri="{FF2B5EF4-FFF2-40B4-BE49-F238E27FC236}">
                        <a16:creationId xmlns:a16="http://schemas.microsoft.com/office/drawing/2014/main" id="{6C982CE3-F7B0-BC90-85C7-3EF6325923B5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9"/>
                    </p:custDataLst>
                  </p:nvPr>
                </p:nvPicPr>
                <p:blipFill>
                  <a:blip r:embed="rId27"/>
                  <a:stretch>
                    <a:fillRect/>
                  </a:stretch>
                </p:blipFill>
                <p:spPr>
                  <a:xfrm>
                    <a:off x="4117743" y="4010499"/>
                    <a:ext cx="877824" cy="173736"/>
                  </a:xfrm>
                  <a:prstGeom prst="rect">
                    <a:avLst/>
                  </a:prstGeom>
                </p:spPr>
              </p:pic>
              <p:sp>
                <p:nvSpPr>
                  <p:cNvPr id="46" name="Text 0">
                    <a:extLst>
                      <a:ext uri="{FF2B5EF4-FFF2-40B4-BE49-F238E27FC236}">
                        <a16:creationId xmlns:a16="http://schemas.microsoft.com/office/drawing/2014/main" id="{76DD68AB-FD30-F256-8E2E-5E394908349C}"/>
                      </a:ext>
                    </a:extLst>
                  </p:cNvPr>
                  <p:cNvSpPr/>
                  <p:nvPr/>
                </p:nvSpPr>
                <p:spPr>
                  <a:xfrm>
                    <a:off x="2414588" y="4884332"/>
                    <a:ext cx="521149" cy="247659"/>
                  </a:xfrm>
                  <a:prstGeom prst="rect">
                    <a:avLst/>
                  </a:prstGeom>
                  <a:noFill/>
                  <a:ln/>
                </p:spPr>
                <p:txBody>
                  <a:bodyPr wrap="square" lIns="0" tIns="0" rIns="0" bIns="0" rtlCol="0" anchor="t"/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RAI&lt;8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47" name="Text 1">
                    <a:extLst>
                      <a:ext uri="{FF2B5EF4-FFF2-40B4-BE49-F238E27FC236}">
                        <a16:creationId xmlns:a16="http://schemas.microsoft.com/office/drawing/2014/main" id="{4B33102B-218C-0BA8-9CCD-89900EBD923D}"/>
                      </a:ext>
                    </a:extLst>
                  </p:cNvPr>
                  <p:cNvSpPr/>
                  <p:nvPr/>
                </p:nvSpPr>
                <p:spPr>
                  <a:xfrm>
                    <a:off x="2404288" y="3914162"/>
                    <a:ext cx="521149" cy="247659"/>
                  </a:xfrm>
                  <a:prstGeom prst="rect">
                    <a:avLst/>
                  </a:prstGeom>
                  <a:noFill/>
                  <a:ln/>
                </p:spPr>
                <p:txBody>
                  <a:bodyPr wrap="square" lIns="0" tIns="0" rIns="0" bIns="0" rtlCol="0" anchor="t"/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RAI≥8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48" name="Text 2">
                    <a:extLst>
                      <a:ext uri="{FF2B5EF4-FFF2-40B4-BE49-F238E27FC236}">
                        <a16:creationId xmlns:a16="http://schemas.microsoft.com/office/drawing/2014/main" id="{E344001A-ED04-23C1-9646-A7239A585F73}"/>
                      </a:ext>
                    </a:extLst>
                  </p:cNvPr>
                  <p:cNvSpPr/>
                  <p:nvPr/>
                </p:nvSpPr>
                <p:spPr>
                  <a:xfrm>
                    <a:off x="3907745" y="4464011"/>
                    <a:ext cx="1285127" cy="367911"/>
                  </a:xfrm>
                  <a:prstGeom prst="rect">
                    <a:avLst/>
                  </a:prstGeom>
                  <a:noFill/>
                  <a:ln/>
                </p:spPr>
                <p:txBody>
                  <a:bodyPr wrap="square" lIns="0" tIns="0" rIns="0" bIns="0" rtlCol="0" anchor="t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uNGAL</a:t>
                    </a:r>
                    <a:r>
                      <a: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&lt;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150ng/ml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49" name="Text 3">
                    <a:extLst>
                      <a:ext uri="{FF2B5EF4-FFF2-40B4-BE49-F238E27FC236}">
                        <a16:creationId xmlns:a16="http://schemas.microsoft.com/office/drawing/2014/main" id="{F4DEBA69-4532-86ED-E02B-BC26B5EB80ED}"/>
                      </a:ext>
                    </a:extLst>
                  </p:cNvPr>
                  <p:cNvSpPr/>
                  <p:nvPr/>
                </p:nvSpPr>
                <p:spPr>
                  <a:xfrm>
                    <a:off x="3868635" y="3299098"/>
                    <a:ext cx="1285127" cy="367911"/>
                  </a:xfrm>
                  <a:prstGeom prst="rect">
                    <a:avLst/>
                  </a:prstGeom>
                  <a:noFill/>
                  <a:ln/>
                </p:spPr>
                <p:txBody>
                  <a:bodyPr wrap="square" lIns="0" tIns="0" rIns="0" bIns="0" rtlCol="0" anchor="t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uNGAL</a:t>
                    </a:r>
                    <a:r>
                      <a: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≥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150ng/ml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  <p:pic>
                <p:nvPicPr>
                  <p:cNvPr id="50" name="Image 10" descr="preencoded.png">
                    <a:extLst>
                      <a:ext uri="{FF2B5EF4-FFF2-40B4-BE49-F238E27FC236}">
                        <a16:creationId xmlns:a16="http://schemas.microsoft.com/office/drawing/2014/main" id="{28872359-091F-FAF9-CB33-CA1329F6DA1A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10"/>
                    </p:custDataLst>
                  </p:nvPr>
                </p:nvPicPr>
                <p:blipFill>
                  <a:blip r:embed="rId28"/>
                  <a:stretch>
                    <a:fillRect/>
                  </a:stretch>
                </p:blipFill>
                <p:spPr>
                  <a:xfrm>
                    <a:off x="6836416" y="2586078"/>
                    <a:ext cx="691896" cy="1182624"/>
                  </a:xfrm>
                  <a:prstGeom prst="rect">
                    <a:avLst/>
                  </a:prstGeom>
                </p:spPr>
              </p:pic>
              <p:pic>
                <p:nvPicPr>
                  <p:cNvPr id="51" name="Image 11" descr="preencoded.png">
                    <a:extLst>
                      <a:ext uri="{FF2B5EF4-FFF2-40B4-BE49-F238E27FC236}">
                        <a16:creationId xmlns:a16="http://schemas.microsoft.com/office/drawing/2014/main" id="{2A1B2EF3-DA07-BB65-863B-13A66332984E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11"/>
                    </p:custDataLst>
                  </p:nvPr>
                </p:nvPicPr>
                <p:blipFill>
                  <a:blip r:embed="rId29"/>
                  <a:stretch>
                    <a:fillRect/>
                  </a:stretch>
                </p:blipFill>
                <p:spPr>
                  <a:xfrm>
                    <a:off x="6687565" y="3075380"/>
                    <a:ext cx="313944" cy="173736"/>
                  </a:xfrm>
                  <a:prstGeom prst="rect">
                    <a:avLst/>
                  </a:prstGeom>
                </p:spPr>
              </p:pic>
              <p:pic>
                <p:nvPicPr>
                  <p:cNvPr id="52" name="Image 12" descr="preencoded.png">
                    <a:extLst>
                      <a:ext uri="{FF2B5EF4-FFF2-40B4-BE49-F238E27FC236}">
                        <a16:creationId xmlns:a16="http://schemas.microsoft.com/office/drawing/2014/main" id="{05E32FBD-9C63-C2F8-EF86-9A40BAB744A2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12"/>
                    </p:custDataLst>
                  </p:nvPr>
                </p:nvPicPr>
                <p:blipFill>
                  <a:blip r:embed="rId30"/>
                  <a:stretch>
                    <a:fillRect/>
                  </a:stretch>
                </p:blipFill>
                <p:spPr>
                  <a:xfrm>
                    <a:off x="7934367" y="2906956"/>
                    <a:ext cx="182880" cy="1645920"/>
                  </a:xfrm>
                  <a:prstGeom prst="rect">
                    <a:avLst/>
                  </a:prstGeom>
                </p:spPr>
              </p:pic>
              <p:pic>
                <p:nvPicPr>
                  <p:cNvPr id="53" name="Image 13" descr="preencoded.png">
                    <a:extLst>
                      <a:ext uri="{FF2B5EF4-FFF2-40B4-BE49-F238E27FC236}">
                        <a16:creationId xmlns:a16="http://schemas.microsoft.com/office/drawing/2014/main" id="{10621F18-5B59-0401-F08A-0B5A45A8FC17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13"/>
                    </p:custDataLst>
                  </p:nvPr>
                </p:nvPicPr>
                <p:blipFill>
                  <a:blip r:embed="rId31"/>
                  <a:stretch>
                    <a:fillRect/>
                  </a:stretch>
                </p:blipFill>
                <p:spPr>
                  <a:xfrm>
                    <a:off x="7371982" y="3424964"/>
                    <a:ext cx="1371600" cy="612648"/>
                  </a:xfrm>
                  <a:prstGeom prst="rect">
                    <a:avLst/>
                  </a:prstGeom>
                </p:spPr>
              </p:pic>
              <p:sp>
                <p:nvSpPr>
                  <p:cNvPr id="54" name="Text 4">
                    <a:extLst>
                      <a:ext uri="{FF2B5EF4-FFF2-40B4-BE49-F238E27FC236}">
                        <a16:creationId xmlns:a16="http://schemas.microsoft.com/office/drawing/2014/main" id="{1EAEC273-CDCA-20A8-E153-6111E07027B3}"/>
                      </a:ext>
                    </a:extLst>
                  </p:cNvPr>
                  <p:cNvSpPr/>
                  <p:nvPr/>
                </p:nvSpPr>
                <p:spPr>
                  <a:xfrm>
                    <a:off x="7370925" y="3192719"/>
                    <a:ext cx="1285127" cy="191547"/>
                  </a:xfrm>
                  <a:prstGeom prst="rect">
                    <a:avLst/>
                  </a:prstGeom>
                  <a:solidFill>
                    <a:schemeClr val="bg1"/>
                  </a:solidFill>
                  <a:ln/>
                </p:spPr>
                <p:txBody>
                  <a:bodyPr wrap="square" lIns="0" tIns="0" rIns="0" bIns="0" rtlCol="0" anchor="t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Non-Responder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55" name="Text 5">
                    <a:extLst>
                      <a:ext uri="{FF2B5EF4-FFF2-40B4-BE49-F238E27FC236}">
                        <a16:creationId xmlns:a16="http://schemas.microsoft.com/office/drawing/2014/main" id="{8FEBEFF9-40DE-FD1E-F8DF-3BA6DFD6019C}"/>
                      </a:ext>
                    </a:extLst>
                  </p:cNvPr>
                  <p:cNvSpPr/>
                  <p:nvPr/>
                </p:nvSpPr>
                <p:spPr>
                  <a:xfrm>
                    <a:off x="7396908" y="4093738"/>
                    <a:ext cx="1285127" cy="191547"/>
                  </a:xfrm>
                  <a:prstGeom prst="rect">
                    <a:avLst/>
                  </a:prstGeom>
                  <a:solidFill>
                    <a:schemeClr val="bg1"/>
                  </a:solidFill>
                  <a:ln/>
                </p:spPr>
                <p:txBody>
                  <a:bodyPr wrap="square" lIns="0" tIns="0" rIns="0" bIns="0" rtlCol="0" anchor="t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Roboto" pitchFamily="34" charset="0"/>
                        <a:ea typeface="Roboto" pitchFamily="34" charset="-122"/>
                        <a:cs typeface="Roboto" pitchFamily="34" charset="-120"/>
                      </a:rPr>
                      <a:t>Responder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  <p:pic>
                <p:nvPicPr>
                  <p:cNvPr id="56" name="Image 0" descr="preencoded.png">
                    <a:extLst>
                      <a:ext uri="{FF2B5EF4-FFF2-40B4-BE49-F238E27FC236}">
                        <a16:creationId xmlns:a16="http://schemas.microsoft.com/office/drawing/2014/main" id="{52B212E3-6254-49FC-86A3-E28F0F24F6D7}"/>
                      </a:ext>
                    </a:extLst>
                  </p:cNvPr>
                  <p:cNvPicPr>
                    <a:picLocks noChangeAspect="1"/>
                  </p:cNvPicPr>
                  <p:nvPr>
                    <p:custDataLst>
                      <p:tags r:id="rId14"/>
                    </p:custDataLst>
                  </p:nvPr>
                </p:nvPicPr>
                <p:blipFill>
                  <a:blip r:embed="rId32"/>
                  <a:stretch>
                    <a:fillRect/>
                  </a:stretch>
                </p:blipFill>
                <p:spPr>
                  <a:xfrm>
                    <a:off x="803333" y="3638689"/>
                    <a:ext cx="1371600" cy="941832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24" name="CasellaDiTesto 83">
                  <a:extLst>
                    <a:ext uri="{FF2B5EF4-FFF2-40B4-BE49-F238E27FC236}">
                      <a16:creationId xmlns:a16="http://schemas.microsoft.com/office/drawing/2014/main" id="{A6790470-5734-87DC-D814-A42DC8C83963}"/>
                    </a:ext>
                  </a:extLst>
                </p:cNvPr>
                <p:cNvSpPr txBox="1"/>
                <p:nvPr/>
              </p:nvSpPr>
              <p:spPr>
                <a:xfrm>
                  <a:off x="919355" y="4804077"/>
                  <a:ext cx="1437078" cy="246221"/>
                </a:xfrm>
                <a:prstGeom prst="rect">
                  <a:avLst/>
                </a:prstGeom>
                <a:noFill/>
                <a:ln w="19050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defTabSz="914400">
                    <a:defRPr/>
                  </a:pP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33.3 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pg</a:t>
                  </a: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/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mL</a:t>
                  </a:r>
                  <a:endParaRPr kumimoji="0" lang="it-IT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28" name="CasellaDiTesto 84">
                  <a:extLst>
                    <a:ext uri="{FF2B5EF4-FFF2-40B4-BE49-F238E27FC236}">
                      <a16:creationId xmlns:a16="http://schemas.microsoft.com/office/drawing/2014/main" id="{1A479C90-851A-18D3-601B-AA123B9FB6EF}"/>
                    </a:ext>
                  </a:extLst>
                </p:cNvPr>
                <p:cNvSpPr txBox="1"/>
                <p:nvPr/>
              </p:nvSpPr>
              <p:spPr>
                <a:xfrm>
                  <a:off x="946328" y="3577138"/>
                  <a:ext cx="965329" cy="400110"/>
                </a:xfrm>
                <a:prstGeom prst="rect">
                  <a:avLst/>
                </a:prstGeom>
                <a:noFill/>
                <a:ln w="1905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 defTabSz="914400">
                    <a:defRPr/>
                  </a:pPr>
                  <a:r>
                    <a:rPr lang="it-IT" sz="1000" b="1" kern="1200" dirty="0">
                      <a:solidFill>
                        <a:srgbClr val="C00000"/>
                      </a:solidFill>
                      <a:latin typeface="Calibri" panose="020F0502020204030204"/>
                    </a:rPr>
                    <a:t>70.4</a:t>
                  </a:r>
                  <a:r>
                    <a:rPr lang="it-IT" sz="1000" kern="1200" dirty="0">
                      <a:solidFill>
                        <a:srgbClr val="C00000"/>
                      </a:solidFill>
                      <a:latin typeface="Calibri" panose="020F0502020204030204"/>
                    </a:rPr>
                    <a:t> </a:t>
                  </a:r>
                  <a:r>
                    <a:rPr lang="it-IT" sz="1000" kern="1200" dirty="0" err="1">
                      <a:solidFill>
                        <a:srgbClr val="C00000"/>
                      </a:solidFill>
                      <a:latin typeface="Calibri" panose="020F0502020204030204"/>
                    </a:rPr>
                    <a:t>pg</a:t>
                  </a:r>
                  <a:r>
                    <a:rPr lang="it-IT" sz="1000" kern="1200" dirty="0">
                      <a:solidFill>
                        <a:srgbClr val="C00000"/>
                      </a:solidFill>
                      <a:latin typeface="Calibri" panose="020F0502020204030204"/>
                    </a:rPr>
                    <a:t>/</a:t>
                  </a:r>
                  <a:r>
                    <a:rPr lang="it-IT" sz="1000" kern="1200" dirty="0" err="1">
                      <a:solidFill>
                        <a:srgbClr val="C00000"/>
                      </a:solidFill>
                      <a:latin typeface="Calibri" panose="020F0502020204030204"/>
                    </a:rPr>
                    <a:t>mL</a:t>
                  </a:r>
                  <a:r>
                    <a:rPr lang="it-IT" sz="1000" dirty="0">
                      <a:solidFill>
                        <a:srgbClr val="C00000"/>
                      </a:solidFill>
                      <a:latin typeface="Calibri" panose="020F0502020204030204"/>
                    </a:rPr>
                    <a:t>** 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 </a:t>
                  </a:r>
                </a:p>
              </p:txBody>
            </p:sp>
            <p:sp>
              <p:nvSpPr>
                <p:cNvPr id="29" name="CasellaDiTesto 90">
                  <a:extLst>
                    <a:ext uri="{FF2B5EF4-FFF2-40B4-BE49-F238E27FC236}">
                      <a16:creationId xmlns:a16="http://schemas.microsoft.com/office/drawing/2014/main" id="{73A93EA4-F5D9-A135-DF9E-FF205B8389EE}"/>
                    </a:ext>
                  </a:extLst>
                </p:cNvPr>
                <p:cNvSpPr txBox="1"/>
                <p:nvPr/>
              </p:nvSpPr>
              <p:spPr>
                <a:xfrm>
                  <a:off x="2476936" y="4789418"/>
                  <a:ext cx="752129" cy="246221"/>
                </a:xfrm>
                <a:prstGeom prst="rect">
                  <a:avLst/>
                </a:prstGeom>
                <a:noFill/>
                <a:ln w="1905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defTabSz="914400">
                    <a:defRPr/>
                  </a:pP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42.1 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pg</a:t>
                  </a: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/ml</a:t>
                  </a:r>
                </a:p>
              </p:txBody>
            </p:sp>
            <p:sp>
              <p:nvSpPr>
                <p:cNvPr id="30" name="CasellaDiTesto 2">
                  <a:extLst>
                    <a:ext uri="{FF2B5EF4-FFF2-40B4-BE49-F238E27FC236}">
                      <a16:creationId xmlns:a16="http://schemas.microsoft.com/office/drawing/2014/main" id="{1D736C54-E8BE-0155-1E5E-A7D5E9ADE4B3}"/>
                    </a:ext>
                  </a:extLst>
                </p:cNvPr>
                <p:cNvSpPr txBox="1"/>
                <p:nvPr/>
              </p:nvSpPr>
              <p:spPr>
                <a:xfrm>
                  <a:off x="1916869" y="2978541"/>
                  <a:ext cx="1912592" cy="415498"/>
                </a:xfrm>
                <a:prstGeom prst="rect">
                  <a:avLst/>
                </a:prstGeom>
                <a:noFill/>
                <a:ln w="19050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 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it-IT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103.7</a:t>
                  </a: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 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pg</a:t>
                  </a: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/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mL</a:t>
                  </a:r>
                  <a:r>
                    <a:rPr lang="it-IT" sz="1000" kern="1200" dirty="0">
                      <a:solidFill>
                        <a:srgbClr val="C00000"/>
                      </a:solidFill>
                      <a:latin typeface="Calibri" panose="020F0502020204030204"/>
                    </a:rPr>
                    <a:t>**</a:t>
                  </a:r>
                  <a:endParaRPr kumimoji="0" lang="it-IT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31" name="CasellaDiTesto 2">
                  <a:extLst>
                    <a:ext uri="{FF2B5EF4-FFF2-40B4-BE49-F238E27FC236}">
                      <a16:creationId xmlns:a16="http://schemas.microsoft.com/office/drawing/2014/main" id="{FBFFF644-AF34-016A-C0FF-6B930F19DB78}"/>
                    </a:ext>
                  </a:extLst>
                </p:cNvPr>
                <p:cNvSpPr txBox="1"/>
                <p:nvPr/>
              </p:nvSpPr>
              <p:spPr>
                <a:xfrm>
                  <a:off x="5082551" y="3022547"/>
                  <a:ext cx="1912592" cy="246221"/>
                </a:xfrm>
                <a:prstGeom prst="rect">
                  <a:avLst/>
                </a:prstGeom>
                <a:noFill/>
                <a:ln w="19050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lvl="0" algn="ctr" defTabSz="914400">
                    <a:defRPr/>
                  </a:pPr>
                  <a:r>
                    <a:rPr lang="it-IT" sz="1000" dirty="0">
                      <a:solidFill>
                        <a:srgbClr val="C00000"/>
                      </a:solidFill>
                      <a:latin typeface="Calibri" panose="020F0502020204030204"/>
                    </a:rPr>
                    <a:t>90.4 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pg</a:t>
                  </a: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/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mL</a:t>
                  </a:r>
                  <a:endParaRPr kumimoji="0" lang="it-IT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32" name="CasellaDiTesto 2">
                  <a:extLst>
                    <a:ext uri="{FF2B5EF4-FFF2-40B4-BE49-F238E27FC236}">
                      <a16:creationId xmlns:a16="http://schemas.microsoft.com/office/drawing/2014/main" id="{0C585707-E2CF-9E7B-A221-00C6B5973B6D}"/>
                    </a:ext>
                  </a:extLst>
                </p:cNvPr>
                <p:cNvSpPr txBox="1"/>
                <p:nvPr/>
              </p:nvSpPr>
              <p:spPr>
                <a:xfrm>
                  <a:off x="5075031" y="4540877"/>
                  <a:ext cx="1912592" cy="246221"/>
                </a:xfrm>
                <a:prstGeom prst="rect">
                  <a:avLst/>
                </a:prstGeom>
                <a:noFill/>
                <a:ln w="19050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lvl="0" algn="ctr" defTabSz="914400">
                    <a:defRPr/>
                  </a:pPr>
                  <a:r>
                    <a:rPr lang="it-IT" sz="1000" dirty="0">
                      <a:solidFill>
                        <a:srgbClr val="C00000"/>
                      </a:solidFill>
                      <a:latin typeface="Calibri" panose="020F0502020204030204"/>
                    </a:rPr>
                    <a:t>76.9 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pg</a:t>
                  </a:r>
                  <a:r>
                    <a:rPr kumimoji="0" lang="it-IT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/</a:t>
                  </a:r>
                  <a:r>
                    <a:rPr kumimoji="0" lang="it-IT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mL</a:t>
                  </a:r>
                  <a:endParaRPr kumimoji="0" lang="it-IT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</p:grp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6EE4684B-BE37-48AE-F63C-AEA61B00F12D}"/>
                  </a:ext>
                </a:extLst>
              </p:cNvPr>
              <p:cNvSpPr txBox="1"/>
              <p:nvPr/>
            </p:nvSpPr>
            <p:spPr>
              <a:xfrm>
                <a:off x="5945603" y="2885496"/>
                <a:ext cx="68998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/>
                <a:r>
                  <a:rPr kumimoji="0" lang="it-IT" sz="11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</a:t>
                </a:r>
                <a:r>
                  <a:rPr kumimoji="0" lang="it-IT" sz="1100" b="1" i="1" u="none" strike="noStrike" kern="1200" cap="none" spc="0" normalizeH="0" baseline="0" noProof="0" dirty="0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=77</a:t>
                </a:r>
                <a:endParaRPr lang="en-IL" sz="1100" dirty="0"/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DFA669F0-AB59-1692-59A4-5D90B8E35390}"/>
                  </a:ext>
                </a:extLst>
              </p:cNvPr>
              <p:cNvSpPr txBox="1"/>
              <p:nvPr/>
            </p:nvSpPr>
            <p:spPr>
              <a:xfrm>
                <a:off x="5945603" y="4126247"/>
                <a:ext cx="68998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/>
                <a:r>
                  <a:rPr kumimoji="0" lang="it-IT" sz="11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</a:t>
                </a:r>
                <a:r>
                  <a:rPr kumimoji="0" lang="it-IT" sz="1100" b="1" i="1" u="none" strike="noStrike" kern="1200" cap="none" spc="0" normalizeH="0" baseline="0" noProof="0" dirty="0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=30</a:t>
                </a:r>
                <a:endParaRPr lang="en-IL" sz="1100" dirty="0"/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05524FC6-9186-F608-E852-37CE008BA04F}"/>
                  </a:ext>
                </a:extLst>
              </p:cNvPr>
              <p:cNvSpPr txBox="1"/>
              <p:nvPr/>
            </p:nvSpPr>
            <p:spPr>
              <a:xfrm>
                <a:off x="7380043" y="4123462"/>
                <a:ext cx="68998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/>
                <a:r>
                  <a:rPr kumimoji="0" lang="it-IT" sz="11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</a:t>
                </a:r>
                <a:r>
                  <a:rPr kumimoji="0" lang="it-IT" sz="1100" b="1" i="1" u="none" strike="noStrike" kern="1200" cap="none" spc="0" normalizeH="0" baseline="0" noProof="0" dirty="0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=25</a:t>
                </a:r>
                <a:endParaRPr lang="en-IL" sz="1100" dirty="0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B8E65060-24CF-175F-2CF7-91937F8E8221}"/>
                  </a:ext>
                </a:extLst>
              </p:cNvPr>
              <p:cNvSpPr txBox="1"/>
              <p:nvPr/>
            </p:nvSpPr>
            <p:spPr>
              <a:xfrm>
                <a:off x="7414599" y="2439329"/>
                <a:ext cx="68998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/>
                <a:r>
                  <a:rPr kumimoji="0" lang="it-IT" sz="11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</a:t>
                </a:r>
                <a:r>
                  <a:rPr kumimoji="0" lang="it-IT" sz="1100" b="1" i="1" u="none" strike="noStrike" kern="1200" cap="none" spc="0" normalizeH="0" baseline="0" noProof="0" dirty="0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=39</a:t>
                </a:r>
                <a:endParaRPr lang="en-IL" sz="1100" dirty="0"/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5AA51D94-563A-EB2F-D5E7-53F3593EF8D5}"/>
                  </a:ext>
                </a:extLst>
              </p:cNvPr>
              <p:cNvSpPr txBox="1"/>
              <p:nvPr/>
            </p:nvSpPr>
            <p:spPr>
              <a:xfrm>
                <a:off x="10612998" y="2330760"/>
                <a:ext cx="68998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/>
                <a:r>
                  <a:rPr kumimoji="0" lang="it-IT" sz="11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</a:t>
                </a:r>
                <a:r>
                  <a:rPr kumimoji="0" lang="it-IT" sz="1100" b="1" i="1" u="none" strike="noStrike" kern="1200" cap="none" spc="0" normalizeH="0" baseline="0" noProof="0" dirty="0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=11</a:t>
                </a:r>
                <a:endParaRPr lang="en-IL" sz="1100" dirty="0"/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8C834DB7-3799-BADA-C203-14027E65E156}"/>
                  </a:ext>
                </a:extLst>
              </p:cNvPr>
              <p:cNvSpPr txBox="1"/>
              <p:nvPr/>
            </p:nvSpPr>
            <p:spPr>
              <a:xfrm>
                <a:off x="10612998" y="3844164"/>
                <a:ext cx="68998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/>
                <a:r>
                  <a:rPr kumimoji="0" lang="it-IT" sz="11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</a:t>
                </a:r>
                <a:r>
                  <a:rPr kumimoji="0" lang="it-IT" sz="1100" b="1" i="1" u="none" strike="noStrike" kern="1200" cap="none" spc="0" normalizeH="0" baseline="0" noProof="0" dirty="0">
                    <a:ln>
                      <a:noFill/>
                    </a:ln>
                    <a:solidFill>
                      <a:srgbClr val="0070C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=6</a:t>
                </a:r>
                <a:endParaRPr lang="en-IL" sz="1100" dirty="0"/>
              </a:p>
            </p:txBody>
          </p:sp>
        </p:grp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BEE835A-556D-2CD3-2833-22E59ACD64DB}"/>
                </a:ext>
              </a:extLst>
            </p:cNvPr>
            <p:cNvSpPr txBox="1"/>
            <p:nvPr/>
          </p:nvSpPr>
          <p:spPr>
            <a:xfrm>
              <a:off x="4711591" y="4090402"/>
              <a:ext cx="9865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i="1" dirty="0">
                  <a:solidFill>
                    <a:srgbClr val="C00000"/>
                  </a:solidFill>
                  <a:latin typeface="Calibri "/>
                </a:rPr>
                <a:t>**p</a:t>
              </a:r>
              <a:r>
                <a:rPr lang="en-IL" sz="1100" b="1" i="1" dirty="0">
                  <a:solidFill>
                    <a:srgbClr val="C00000"/>
                  </a:solidFill>
                  <a:latin typeface="Calibri "/>
                </a:rPr>
                <a:t>&lt;0.01</a:t>
              </a:r>
            </a:p>
          </p:txBody>
        </p:sp>
      </p:grpSp>
      <p:grpSp>
        <p:nvGrpSpPr>
          <p:cNvPr id="90" name="Group 89">
            <a:extLst>
              <a:ext uri="{FF2B5EF4-FFF2-40B4-BE49-F238E27FC236}">
                <a16:creationId xmlns:a16="http://schemas.microsoft.com/office/drawing/2014/main" id="{2B485F03-3FA6-2CEB-40B5-2DFB8961593A}"/>
              </a:ext>
            </a:extLst>
          </p:cNvPr>
          <p:cNvGrpSpPr/>
          <p:nvPr/>
        </p:nvGrpSpPr>
        <p:grpSpPr>
          <a:xfrm>
            <a:off x="2628151" y="3021853"/>
            <a:ext cx="732761" cy="648224"/>
            <a:chOff x="1752600" y="2632505"/>
            <a:chExt cx="944142" cy="863706"/>
          </a:xfrm>
        </p:grpSpPr>
        <p:sp>
          <p:nvSpPr>
            <p:cNvPr id="92" name="Freeform: Shape 46">
              <a:extLst>
                <a:ext uri="{FF2B5EF4-FFF2-40B4-BE49-F238E27FC236}">
                  <a16:creationId xmlns:a16="http://schemas.microsoft.com/office/drawing/2014/main" id="{85727512-4A1C-61C9-6BF8-36D33441A110}"/>
                </a:ext>
              </a:extLst>
            </p:cNvPr>
            <p:cNvSpPr/>
            <p:nvPr/>
          </p:nvSpPr>
          <p:spPr>
            <a:xfrm>
              <a:off x="2274485" y="2632505"/>
              <a:ext cx="422257" cy="863706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C000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870F8231-B146-A4CD-2C1B-6B6794C621B2}"/>
                </a:ext>
              </a:extLst>
            </p:cNvPr>
            <p:cNvGrpSpPr/>
            <p:nvPr/>
          </p:nvGrpSpPr>
          <p:grpSpPr>
            <a:xfrm>
              <a:off x="1752600" y="2632505"/>
              <a:ext cx="422257" cy="863706"/>
              <a:chOff x="1979496" y="2632505"/>
              <a:chExt cx="422257" cy="863706"/>
            </a:xfrm>
            <a:solidFill>
              <a:srgbClr val="7030A0"/>
            </a:solidFill>
          </p:grpSpPr>
          <p:sp>
            <p:nvSpPr>
              <p:cNvPr id="94" name="Freeform: Shape 46">
                <a:extLst>
                  <a:ext uri="{FF2B5EF4-FFF2-40B4-BE49-F238E27FC236}">
                    <a16:creationId xmlns:a16="http://schemas.microsoft.com/office/drawing/2014/main" id="{F8E7A2F0-370C-485E-9305-5A4C84D57446}"/>
                  </a:ext>
                </a:extLst>
              </p:cNvPr>
              <p:cNvSpPr/>
              <p:nvPr/>
            </p:nvSpPr>
            <p:spPr>
              <a:xfrm>
                <a:off x="1979496" y="2632505"/>
                <a:ext cx="422257" cy="863706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chemeClr val="tx2">
                  <a:lumMod val="75000"/>
                </a:schemeClr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95" name="Triangle 94">
                <a:extLst>
                  <a:ext uri="{FF2B5EF4-FFF2-40B4-BE49-F238E27FC236}">
                    <a16:creationId xmlns:a16="http://schemas.microsoft.com/office/drawing/2014/main" id="{8731B17B-9696-68CD-EB23-CAEF5DCCD623}"/>
                  </a:ext>
                </a:extLst>
              </p:cNvPr>
              <p:cNvSpPr/>
              <p:nvPr/>
            </p:nvSpPr>
            <p:spPr>
              <a:xfrm>
                <a:off x="2009726" y="2931282"/>
                <a:ext cx="361796" cy="361996"/>
              </a:xfrm>
              <a:prstGeom prst="triangle">
                <a:avLst/>
              </a:prstGeom>
              <a:solidFill>
                <a:schemeClr val="tx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L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3444712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" fill="hold">
                      <p:stCondLst>
                        <p:cond delay="indefinite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500"/>
                                        <p:tgtEl>
                                          <p:spTgt spid="9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7" grpId="0"/>
      <p:bldP spid="18" grpId="0"/>
      <p:bldP spid="27" grpId="0"/>
      <p:bldP spid="98" grpId="0" animBg="1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5e7cd39d-5297-41ab-991f-41a7b24978df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5e7cd39d-5297-41ab-991f-41a7b24978df&quot;:{&quot;type&quot;:&quot;FIGURE_OBJECT&quot;,&quot;id&quot;:&quot;5e7cd39d-5297-41ab-991f-41a7b24978df&quot;,&quot;relativeTransform&quot;:{&quot;translate&quot;:{&quot;x&quot;:-223.920183582152,&quot;y&quot;:95.45639757707258},&quot;rotate&quot;:0},&quot;opacity&quot;:1,&quot;path&quot;:{&quot;type&quot;:&quot;POLY_LINE&quot;,&quot;points&quot;:[{&quot;x&quot;:-55.69024289867461,&quot;y&quot;:0},{&quot;x&quot;:55.69024289867461,&quot;y&quot;:0}],&quot;closed&quot;:false},&quot;pathStyles&quot;:[{&quot;type&quot;:&quot;FILL&quot;,&quot;fillStyle&quot;:&quot;rgba(0,0,0,0)&quot;},{&quot;type&quot;:&quot;STROKE&quot;,&quot;strokeStyle&quot;:&quot;#232323&quot;,&quot;lineWidth&quot;:2.2344300486599096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44043c-d176-4440-b2e8-cb14435cb098&quot;,&quot;order&quot;:&quot;1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8657a5f4-9930-4024-a972-1fe026e3091c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8657a5f4-9930-4024-a972-1fe026e3091c&quot;:{&quot;type&quot;:&quot;FIGURE_OBJECT&quot;,&quot;id&quot;:&quot;8657a5f4-9930-4024-a972-1fe026e3091c&quot;,&quot;relativeTransform&quot;:{&quot;translate&quot;:{&quot;x&quot;:274.0539427106288,&quot;y&quot;:-2.4157691973075153},&quot;rotate&quot;:0},&quot;opacity&quot;:1,&quot;path&quot;:{&quot;type&quot;:&quot;POLY_LINE&quot;,&quot;points&quot;:[{&quot;x&quot;:27.135478876384663,&quot;y&quot;:52.975318053731556},{&quot;x&quot;:-27.13547887638479,&quot;y&quot;:52.975318053731556},{&quot;x&quot;:-27.13547887638479,&quot;y&quot;:-52.975318053731804},{&quot;x&quot;:27.135478876384663,&quot;y&quot;:-52.975318053731804}],&quot;closed&quot;:false},&quot;pathStyles&quot;:[{&quot;type&quot;:&quot;FILL&quot;,&quot;fillStyle&quot;:&quot;rgba(0,0,0,0)&quot;},{&quot;type&quot;:&quot;STROKE&quot;,&quot;strokeStyle&quot;:&quot;#232323&quot;,&quot;lineWidth&quot;:2.2344300486599096,&quot;lineJoin&quot;:&quot;round&quot;}],&quot;pathMarkers&quot;:{&quot;markerStart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,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44043c-d176-4440-b2e8-cb14435cb098&quot;,&quot;order&quot;:&quot;6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ccc38560-cf0e-4c1c-af89-68f8644843fb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ccc38560-cf0e-4c1c-af89-68f8644843fb&quot;:{&quot;type&quot;:&quot;FIGURE_OBJECT&quot;,&quot;id&quot;:&quot;ccc38560-cf0e-4c1c-af89-68f8644843fb&quot;,&quot;relativeTransform&quot;:{&quot;translate&quot;:{&quot;x&quot;:238.58654162256835,&quot;y&quot;:-4.00547937521311},&quot;rotate&quot;:0},&quot;opacity&quot;:1,&quot;path&quot;:{&quot;type&quot;:&quot;POLY_LINE&quot;,&quot;points&quot;:[{&quot;x&quot;:-7.375264353261334,&quot;y&quot;:0},{&quot;x&quot;:7.375264353261334,&quot;y&quot;:0}],&quot;closed&quot;:false},&quot;pathStyles&quot;:[{&quot;type&quot;:&quot;FILL&quot;,&quot;fillStyle&quot;:&quot;rgba(0,0,0,0)&quot;},{&quot;type&quot;:&quot;STROKE&quot;,&quot;strokeStyle&quot;:&quot;#232323&quot;,&quot;lineWidth&quot;:2.2344300486599096,&quot;lineJoin&quot;:&quot;round&quot;}],&quot;isLocked&quot;:false,&quot;parent&quot;:{&quot;type&quot;:&quot;CHILD&quot;,&quot;parentId&quot;:&quot;2d44043c-d176-4440-b2e8-cb14435cb098&quot;,&quot;order&quot;:&quot;7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67b019d6-e93d-4698-a235-ad830a93d322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67b019d6-e93d-4698-a235-ad830a93d322&quot;:{&quot;type&quot;:&quot;FIGURE_OBJECT&quot;,&quot;id&quot;:&quot;67b019d6-e93d-4698-a235-ad830a93d322&quot;,&quot;relativeTransform&quot;:{&quot;translate&quot;:{&quot;x&quot;:-24.415068865534522,&quot;y&quot;:65.77634322965834},&quot;rotate&quot;:0},&quot;opacity&quot;:1,&quot;path&quot;:{&quot;type&quot;:&quot;POLY_LINE&quot;,&quot;points&quot;:[{&quot;x&quot;:386.50863186207977,&quot;y&quot;:-87.51057284665532},{&quot;x&quot;:387.53041391765714,&quot;y&quot;:67.14224651639037}],&quot;closed&quot;:false},&quot;pathStyles&quot;:[{&quot;type&quot;:&quot;FILL&quot;,&quot;fillStyle&quot;:&quot;rgba(0,0,0,0)&quot;},{&quot;type&quot;:&quot;STROKE&quot;,&quot;strokeStyle&quot;:&quot;#232323&quot;,&quot;lineWidth&quot;:2.2344300486599096,&quot;lineJoin&quot;:&quot;round&quot;}],&quot;pathMarkers&quot;:{&quot;markerStart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,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44043c-d176-4440-b2e8-cb14435cb098&quot;,&quot;order&quot;:&quot;72&quot;},&quot;connectorInfo&quot;:{&quot;connectedObjects&quot;:[],&quot;type&quot;:&quot;LINE&quot;,&quot;offset&quot;:{&quot;x&quot;:0,&quot;y&quot;:0},&quot;bending&quot;:0.1,&quot;firstElementIsHead&quot;:false,&quot;customized&quot;:false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2f639977-11df-4841-b64c-ba27dada6097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2f639977-11df-4841-b64c-ba27dada6097&quot;:{&quot;type&quot;:&quot;FIGURE_OBJECT&quot;,&quot;id&quot;:&quot;2f639977-11df-4841-b64c-ba27dada6097&quot;,&quot;relativeTransform&quot;:{&quot;translate&quot;:{&quot;x&quot;:365.96139158076704,&quot;y&quot;:55.7363075100194},&quot;rotate&quot;:0},&quot;layout&quot;:{&quot;sizeRatio&quot;:{&quot;x&quot;:0.88,&quot;y&quot;:0.88},&quot;keepAspectRatio&quot;:false},&quot;opacity&quot;:1,&quot;path&quot;:{&quot;type&quot;:&quot;RECT&quot;,&quot;size&quot;:{&quot;x&quot;:125.70185644498949,&quot;y&quot;:45.973446021410915},&quot;cornerRounding&quot;:{&quot;type&quot;:&quot;ARC_LENGTH&quot;,&quot;global&quot;:1.754917256457564}},&quot;pathStyles&quot;:[{&quot;type&quot;:&quot;FILL&quot;,&quot;fillStyle&quot;:&quot;rgba(253,240,246,1)&quot;},{&quot;type&quot;:&quot;STROKE&quot;,&quot;strokeStyle&quot;:&quot;rgba(66, 59, 100, 1)&quot;,&quot;lineWidth&quot;:2.2344300486599096,&quot;lineJoin&quot;:&quot;round&quot;}],&quot;isLocked&quot;:false,&quot;parent&quot;:{&quot;type&quot;:&quot;CHILD&quot;,&quot;parentId&quot;:&quot;2d44043c-d176-4440-b2e8-cb14435cb098&quot;,&quot;order&quot;:&quot;75&quot;}},&quot;17819acd-233f-4baa-94a8-9bf822b8d642&quot;:{&quot;type&quot;:&quot;FIGURE_OBJECT&quot;,&quot;id&quot;:&quot;17819acd-233f-4baa-94a8-9bf822b8d642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5.641010340619367,&quot;color&quot;:&quot;rgb(0,0,0)&quot;,&quot;fontWeight&quot;:&quot;normal&quot;,&quot;fontStyle&quot;:&quot;normal&quot;,&quot;decoration&quot;:&quot;none&quot;,&quot;script&quot;:&quot;none&quot;},&quot;range&quot;:[0,21]}],&quot;text&quot;:&quot;Furosemide Stress Test&quot;}],&quot;verticalAlign&quot;:&quot;TOP&quot;,&quot;_lastCaretLocation&quot;:{&quot;lineIndex&quot;:0,&quot;runIndex&quot;:-1,&quot;charIndex&quot;:-1,&quot;endOfLine&quot;:true}},&quot;size&quot;:{&quot;x&quot;:110.61763367159077,&quot;y&quot;:35.54978207417916},&quot;targetSize&quot;:{&quot;x&quot;:110.61763367159077,&quot;y&quot;:2},&quot;format&quot;:&quot;BETTER_TEXT&quot;},&quot;parent&quot;:{&quot;type&quot;:&quot;CHILD&quot;,&quot;parentId&quot;:&quot;2f639977-11df-4841-b64c-ba27dada6097&quot;,&quot;order&quot;:&quot;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7261094a-02bb-4710-a5b3-da48caf75c64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7261094a-02bb-4710-a5b3-da48caf75c64&quot;:{&quot;type&quot;:&quot;FIGURE_OBJECT&quot;,&quot;id&quot;:&quot;7261094a-02bb-4710-a5b3-da48caf75c64&quot;,&quot;relativeTransform&quot;:{&quot;translate&quot;:{&quot;x&quot;:-341.47501933758855,&quot;y&quot;:95.45658628081138},&quot;rotate&quot;:0},&quot;layout&quot;:{&quot;sizeRatio&quot;:{&quot;x&quot;:0.88,&quot;y&quot;:0.88},&quot;keepAspectRatio&quot;:false},&quot;opacity&quot;:1,&quot;path&quot;:{&quot;type&quot;:&quot;RECT&quot;,&quot;size&quot;:{&quot;x&quot;:125.70185644498949,&quot;y&quot;:80.5664380045215},&quot;cornerRounding&quot;:{&quot;type&quot;:&quot;ARC_LENGTH&quot;,&quot;global&quot;:37.86237732672542}},&quot;pathStyles&quot;:[{&quot;type&quot;:&quot;FILL&quot;,&quot;fillStyle&quot;:&quot;rgba(240,248,245,1)&quot;},{&quot;type&quot;:&quot;STROKE&quot;,&quot;strokeStyle&quot;:&quot;rgba(79, 96, 156, 1)&quot;,&quot;lineWidth&quot;:2.2344300486599096,&quot;lineJoin&quot;:&quot;round&quot;}],&quot;isLocked&quot;:false,&quot;parent&quot;:{&quot;type&quot;:&quot;CHILD&quot;,&quot;parentId&quot;:&quot;2d44043c-d176-4440-b2e8-cb14435cb098&quot;,&quot;order&quot;:&quot;02&quot;}},&quot;2e8e17a9-324c-41d4-86b1-967892597a58&quot;:{&quot;type&quot;:&quot;FIGURE_OBJECT&quot;,&quot;id&quot;:&quot;2e8e17a9-324c-41d4-86b1-967892597a58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5.641010340619367,&quot;color&quot;:&quot;rgb(0,0,0)&quot;,&quot;fontWeight&quot;:&quot;normal&quot;,&quot;fontStyle&quot;:&quot;normal&quot;,&quot;decoration&quot;:&quot;none&quot;,&quot;script&quot;:&quot;none&quot;},&quot;range&quot;:[0,43]}],&quot;text&quot;:&quot;Renal Angina Assessment  in the 1st 12 hours&quot;}],&quot;verticalAlign&quot;:&quot;TOP&quot;,&quot;_lastCaretLocation&quot;:{&quot;lineIndex&quot;:0,&quot;runIndex&quot;:-1,&quot;charIndex&quot;:-1,&quot;endOfLine&quot;:true}},&quot;size&quot;:{&quot;x&quot;:110.61763367159077,&quot;y&quot;:70.89846544397892},&quot;targetSize&quot;:{&quot;x&quot;:110.61763367159077,&quot;y&quot;:2},&quot;format&quot;:&quot;BETTER_TEXT&quot;},&quot;parent&quot;:{&quot;type&quot;:&quot;CHILD&quot;,&quot;parentId&quot;:&quot;7261094a-02bb-4710-a5b3-da48caf75c64&quot;,&quot;order&quot;:&quot;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40d320fb-3210-46e0-b5eb-2d97a979d41e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40d320fb-3210-46e0-b5eb-2d97a979d41e&quot;:{&quot;type&quot;:&quot;FIGURE_OBJECT&quot;,&quot;id&quot;:&quot;40d320fb-3210-46e0-b5eb-2d97a979d41e&quot;,&quot;relativeTransform&quot;:{&quot;translate&quot;:{&quot;x&quot;:-204.76417328780906,&quot;y&quot;:146.00652741980326},&quot;rotate&quot;:0},&quot;opacity&quot;:1,&quot;path&quot;:{&quot;type&quot;:&quot;POLY_LINE&quot;,&quot;points&quot;:[{&quot;x&quot;:40.429925288300616,&quot;y&quot;:50.44553868445194},{&quot;x&quot;:-36.53474806242181,&quot;y&quot;:50.44553868445194},{&quot;x&quot;:-36.534748062422146,&quot;y&quot;:-50.44553868445194},{&quot;x&quot;:36.534748062422146,&quot;y&quot;:-50.44553868445194}],&quot;closed&quot;:false},&quot;pathStyles&quot;:[{&quot;type&quot;:&quot;FILL&quot;,&quot;fillStyle&quot;:&quot;rgba(0,0,0,0)&quot;},{&quot;type&quot;:&quot;STROKE&quot;,&quot;strokeStyle&quot;:&quot;#232323&quot;,&quot;lineWidth&quot;:2.2344405437478985,&quot;lineJoin&quot;:&quot;round&quot;}],&quot;pathMarkers&quot;:{&quot;markerStart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,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44043c-d176-4440-b2e8-cb14435cb098&quot;,&quot;order&quot;:&quot;12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6029d921-d344-493b-8103-d8df63bd82c1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6029d921-d344-493b-8103-d8df63bd82c1&quot;:{&quot;type&quot;:&quot;FIGURE_OBJECT&quot;,&quot;id&quot;:&quot;6029d921-d344-493b-8103-d8df63bd82c1&quot;,&quot;relativeTransform&quot;:{&quot;translate&quot;:{&quot;x&quot;:-103.14446292437837,&quot;y&quot;:94.93365597629504},&quot;rotate&quot;:0},&quot;layout&quot;:{&quot;sizeRatio&quot;:{&quot;x&quot;:0.88,&quot;y&quot;:0.88},&quot;keepAspectRatio&quot;:false},&quot;opacity&quot;:1,&quot;path&quot;:{&quot;type&quot;:&quot;RECT&quot;,&quot;size&quot;:{&quot;x&quot;:125.70185644498949,&quot;y&quot;:45.973446021410915},&quot;cornerRounding&quot;:{&quot;type&quot;:&quot;ARC_LENGTH&quot;,&quot;global&quot;:1.754917256457564}},&quot;pathStyles&quot;:[{&quot;type&quot;:&quot;FILL&quot;,&quot;fillStyle&quot;:&quot;rgba(211, 238, 234, 1)&quot;},{&quot;type&quot;:&quot;STROKE&quot;,&quot;strokeStyle&quot;:&quot;rgba(34, 98, 88, 1)&quot;,&quot;lineWidth&quot;:2.2344300486599096,&quot;lineJoin&quot;:&quot;round&quot;}],&quot;isLocked&quot;:false,&quot;parent&quot;:{&quot;type&quot;:&quot;CHILD&quot;,&quot;parentId&quot;:&quot;2d44043c-d176-4440-b2e8-cb14435cb098&quot;,&quot;order&quot;:&quot;15&quot;}},&quot;522e242e-1910-4083-bf6b-34a265456e9b&quot;:{&quot;type&quot;:&quot;FIGURE_OBJECT&quot;,&quot;id&quot;:&quot;522e242e-1910-4083-bf6b-34a265456e9b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5.641010340619367,&quot;color&quot;:&quot;rgb(0,0,0)&quot;,&quot;fontWeight&quot;:&quot;normal&quot;,&quot;fontStyle&quot;:&quot;normal&quot;,&quot;decoration&quot;:&quot;none&quot;,&quot;script&quot;:&quot;none&quot;},&quot;range&quot;:[0,21]}],&quot;text&quot;:&quot;Urine NGAL Assessment &quot;}],&quot;verticalAlign&quot;:&quot;TOP&quot;,&quot;_lastCaretLocation&quot;:{&quot;lineIndex&quot;:0,&quot;runIndex&quot;:-1,&quot;charIndex&quot;:-1,&quot;endOfLine&quot;:true}},&quot;size&quot;:{&quot;x&quot;:110.61763367159077,&quot;y&quot;:35.54978207417916},&quot;targetSize&quot;:{&quot;x&quot;:110.61763367159077,&quot;y&quot;:2},&quot;format&quot;:&quot;BETTER_TEXT&quot;},&quot;parent&quot;:{&quot;type&quot;:&quot;CHILD&quot;,&quot;parentId&quot;:&quot;6029d921-d344-493b-8103-d8df63bd82c1&quot;,&quot;order&quot;:&quot;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91a3936d-d06d-4015-aca4-00b640047a92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91a3936d-d06d-4015-aca4-00b640047a92&quot;:{&quot;type&quot;:&quot;FIGURE_OBJECT&quot;,&quot;id&quot;:&quot;91a3936d-d06d-4015-aca4-00b640047a92&quot;,&quot;relativeTransform&quot;:{&quot;translate&quot;:{&quot;x&quot;:365.9613916637735,&quot;y&quot;:175.4366571804312},&quot;rotate&quot;:0},&quot;layout&quot;:{&quot;sizeRatio&quot;:{&quot;x&quot;:0.88,&quot;y&quot;:0.88},&quot;keepAspectRatio&quot;:false},&quot;opacity&quot;:1,&quot;path&quot;:{&quot;type&quot;:&quot;RECT&quot;,&quot;size&quot;:{&quot;x&quot;:125.70185644498949,&quot;y&quot;:80.5664380045215},&quot;cornerRounding&quot;:{&quot;type&quot;:&quot;ARC_LENGTH&quot;,&quot;global&quot;:1.754917256457564}},&quot;pathStyles&quot;:[{&quot;type&quot;:&quot;FILL&quot;,&quot;fillStyle&quot;:&quot;rgba(223, 237, 250, 1)&quot;},{&quot;type&quot;:&quot;STROKE&quot;,&quot;strokeStyle&quot;:&quot;rgba(66, 59, 100, 1)&quot;,&quot;lineWidth&quot;:2.2344300486599096,&quot;lineJoin&quot;:&quot;round&quot;}],&quot;isLocked&quot;:false,&quot;parent&quot;:{&quot;type&quot;:&quot;CHILD&quot;,&quot;parentId&quot;:&quot;2d44043c-d176-4440-b2e8-cb14435cb098&quot;,&quot;order&quot;:&quot;2&quot;}},&quot;6c934e5a-e220-4fc3-b927-9baf7e244449&quot;:{&quot;type&quot;:&quot;FIGURE_OBJECT&quot;,&quot;id&quot;:&quot;6c934e5a-e220-4fc3-b927-9baf7e244449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5.641010340619367,&quot;color&quot;:&quot;rgb(0,0,0)&quot;,&quot;fontWeight&quot;:&quot;normal&quot;,&quot;fontStyle&quot;:&quot;normal&quot;,&quot;decoration&quot;:&quot;none&quot;,&quot;script&quot;:&quot;none&quot;},&quot;range&quot;:[0,39]}],&quot;text&quot;:&quot;Continue Standard Management + Diuretics&quot;}],&quot;verticalAlign&quot;:&quot;TOP&quot;,&quot;_lastCaretLocation&quot;:{&quot;lineIndex&quot;:0,&quot;runIndex&quot;:0,&quot;charIndex&quot;:28}},&quot;size&quot;:{&quot;x&quot;:110.61763367159077,&quot;y&quot;:70.89846544397892},&quot;targetSize&quot;:{&quot;x&quot;:110.61763367159077,&quot;y&quot;:2},&quot;format&quot;:&quot;BETTER_TEXT&quot;},&quot;parent&quot;:{&quot;type&quot;:&quot;CHILD&quot;,&quot;parentId&quot;:&quot;91a3936d-d06d-4015-aca4-00b640047a92&quot;,&quot;order&quot;:&quot;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88b593e0-c9e8-40ba-b7f3-d5c68a7f6f8f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88b593e0-c9e8-40ba-b7f3-d5c68a7f6f8f&quot;:{&quot;type&quot;:&quot;FIGURE_OBJECT&quot;,&quot;id&quot;:&quot;88b593e0-c9e8-40ba-b7f3-d5c68a7f6f8f&quot;,&quot;relativeTransform&quot;:{&quot;translate&quot;:{&quot;x&quot;:367.176247953909,&quot;y&quot;:-56.365265789598666},&quot;rotate&quot;:0},&quot;layout&quot;:{&quot;sizeRatio&quot;:{&quot;x&quot;:0.88,&quot;y&quot;:0.88},&quot;keepAspectRatio&quot;:false},&quot;opacity&quot;:1,&quot;path&quot;:{&quot;type&quot;:&quot;RECT&quot;,&quot;size&quot;:{&quot;x&quot;:125.70185644498949,&quot;y&quot;:60.481958817135286},&quot;cornerRounding&quot;:{&quot;type&quot;:&quot;ARC_LENGTH&quot;,&quot;global&quot;:1.754917256457564}},&quot;pathStyles&quot;:[{&quot;type&quot;:&quot;FILL&quot;,&quot;fillStyle&quot;:&quot;rgba(244,248,241,1)&quot;},{&quot;type&quot;:&quot;STROKE&quot;,&quot;strokeStyle&quot;:&quot;rgba(45, 95, 138, 1)&quot;,&quot;lineWidth&quot;:2.2344300486599096,&quot;lineJoin&quot;:&quot;round&quot;}],&quot;isLocked&quot;:false,&quot;parent&quot;:{&quot;type&quot;:&quot;CHILD&quot;,&quot;parentId&quot;:&quot;2d44043c-d176-4440-b2e8-cb14435cb098&quot;,&quot;order&quot;:&quot;22&quot;}},&quot;92c7f44d-9914-46f7-b350-d537a611b626&quot;:{&quot;type&quot;:&quot;FIGURE_OBJECT&quot;,&quot;id&quot;:&quot;92c7f44d-9914-46f7-b350-d537a611b626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5.641010340619367,&quot;color&quot;:&quot;rgba(23,23,23,1)&quot;,&quot;fontWeight&quot;:&quot;normal&quot;,&quot;fontStyle&quot;:&quot;normal&quot;,&quot;decoration&quot;:&quot;none&quot;,&quot;script&quot;:&quot;none&quot;},&quot;range&quot;:[0,12]}],&quot;text&quot;:&quot;Fluid Restric&quot;},{&quot;runs&quot;:[{&quot;style&quot;:{&quot;fontFamily&quot;:&quot;Roboto&quot;,&quot;fontSize&quot;:15.641010340619367,&quot;color&quot;:&quot;rgba(23,23,23,1)&quot;,&quot;fontWeight&quot;:&quot;normal&quot;,&quot;fontStyle&quot;:&quot;normal&quot;,&quot;decoration&quot;:&quot;none&quot;,&quot;script&quot;:&quot;none&quot;},&quot;range&quot;:[0,25]}],&quot;text&quot;:&quot;Start KRT at 10-15% ICU FO&quot;}],&quot;verticalAlign&quot;:&quot;TOP&quot;},&quot;size&quot;:{&quot;x&quot;:110.61763367159077,&quot;y&quot;:53.22412375907905},&quot;targetSize&quot;:{&quot;x&quot;:110.61763367159077,&quot;y&quot;:2},&quot;format&quot;:&quot;BETTER_TEXT&quot;},&quot;parent&quot;:{&quot;type&quot;:&quot;CHILD&quot;,&quot;parentId&quot;:&quot;88b593e0-c9e8-40ba-b7f3-d5c68a7f6f8f&quot;,&quot;order&quot;:&quot;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0c5d4e73-9c3d-4307-8d06-d3308dc9b6c0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0c5d4e73-9c3d-4307-8d06-d3308dc9b6c0&quot;:{&quot;type&quot;:&quot;FIGURE_OBJECT&quot;,&quot;id&quot;:&quot;0c5d4e73-9c3d-4307-8d06-d3308dc9b6c0&quot;,&quot;relativeTransform&quot;:{&quot;translate&quot;:{&quot;x&quot;:167.72469473047704,&quot;y&quot;:-5.481875027471837},&quot;rotate&quot;:0},&quot;layout&quot;:{&quot;sizeRatio&quot;:{&quot;x&quot;:0.88,&quot;y&quot;:0.88},&quot;keepAspectRatio&quot;:false},&quot;opacity&quot;:1,&quot;path&quot;:{&quot;type&quot;:&quot;RECT&quot;,&quot;size&quot;:{&quot;x&quot;:125.70185644498949,&quot;y&quot;:45.973446021410915},&quot;cornerRounding&quot;:{&quot;type&quot;:&quot;ARC_LENGTH&quot;,&quot;global&quot;:1.754917256457564}},&quot;pathStyles&quot;:[{&quot;type&quot;:&quot;FILL&quot;,&quot;fillStyle&quot;:&quot;rgba(221, 218, 244, 1)&quot;},{&quot;type&quot;:&quot;STROKE&quot;,&quot;strokeStyle&quot;:&quot;rgba(66, 59, 100, 1)&quot;,&quot;lineWidth&quot;:2.2344300486599096,&quot;lineJoin&quot;:&quot;round&quot;}],&quot;isLocked&quot;:false,&quot;parent&quot;:{&quot;type&quot;:&quot;CHILD&quot;,&quot;parentId&quot;:&quot;2d44043c-d176-4440-b2e8-cb14435cb098&quot;,&quot;order&quot;:&quot;25&quot;}},&quot;ebb1c6e3-e2f3-4c95-97c6-82f61bc01396&quot;:{&quot;type&quot;:&quot;FIGURE_OBJECT&quot;,&quot;id&quot;:&quot;ebb1c6e3-e2f3-4c95-97c6-82f61bc01396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5.641010340619367,&quot;color&quot;:&quot;rgb(0,0,0)&quot;,&quot;fontWeight&quot;:&quot;normal&quot;,&quot;fontStyle&quot;:&quot;normal&quot;,&quot;decoration&quot;:&quot;none&quot;,&quot;script&quot;:&quot;none&quot;},&quot;range&quot;:[0,16]}],&quot;text&quot;:&quot;Clinical Judgment&quot;}],&quot;verticalAlign&quot;:&quot;TOP&quot;,&quot;_lastCaretLocation&quot;:{&quot;lineIndex&quot;:0,&quot;runIndex&quot;:-1,&quot;charIndex&quot;:-1,&quot;endOfLine&quot;:true}},&quot;size&quot;:{&quot;x&quot;:110.61763367159077,&quot;y&quot;:35.54978207417916},&quot;targetSize&quot;:{&quot;x&quot;:110.61763367159077,&quot;y&quot;:2},&quot;format&quot;:&quot;BETTER_TEXT&quot;},&quot;parent&quot;:{&quot;type&quot;:&quot;CHILD&quot;,&quot;parentId&quot;:&quot;0c5d4e73-9c3d-4307-8d06-d3308dc9b6c0&quot;,&quot;order&quot;:&quot;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4484f5d4-6e74-4dc6-a4c9-8a96cb812548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4484f5d4-6e74-4dc6-a4c9-8a96cb812548&quot;:{&quot;type&quot;:&quot;FIGURE_OBJECT&quot;,&quot;id&quot;:&quot;4484f5d4-6e74-4dc6-a4c9-8a96cb812548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40.29292547354956,&quot;y&quot;:197.58607550967372},{&quot;x&quot;:35.93774972796964,&quot;y&quot;:197.70073479852965},{&quot;x&quot;:35.93774972796964,&quot;y&quot;:-6.004705353692067},{&quot;x&quot;:102.536764304965,&quot;y&quot;:-6.004705353692067}],&quot;closed&quot;:false},&quot;pathStyles&quot;:[{&quot;type&quot;:&quot;FILL&quot;,&quot;fillStyle&quot;:&quot;rgba(0,0,0,0)&quot;},{&quot;type&quot;:&quot;STROKE&quot;,&quot;strokeStyle&quot;:&quot;#232323&quot;,&quot;lineWidth&quot;:2.23443004865991,&quot;lineJoin&quot;:&quot;round&quot;}],&quot;pathMarkers&quot;:{&quot;markerStart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,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44043c-d176-4440-b2e8-cb14435cb098&quot;,&quot;order&quot;:&quot;3&quot;},&quot;connectorInfo&quot;:{&quot;connectedObjects&quot;:[{&quot;objectId&quot;:&quot;ac5aab61-1b2f-4aa1-8f62-adc4cf6652aa&quot;,&quot;coordinates&quot;:{&quot;x&quot;:1,&quot;y&quot;:0.6099914841437095}}],&quot;type&quot;:&quot;ELBOW&quot;,&quot;offset&quot;:{&quot;x&quot;:0,&quot;y&quot;:0},&quot;bending&quot;:-0.1,&quot;firstElementIsHead&quot;:true,&quot;customized&quot;:true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ac5aab61-1b2f-4aa1-8f62-adc4cf6652aa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ac5aab61-1b2f-4aa1-8f62-adc4cf6652aa&quot;:{&quot;type&quot;:&quot;FIGURE_OBJECT&quot;,&quot;id&quot;:&quot;ac5aab61-1b2f-4aa1-8f62-adc4cf6652aa&quot;,&quot;relativeTransform&quot;:{&quot;translate&quot;:{&quot;x&quot;:-103.1438536960443,&quot;y&quot;:188.72445342138423},&quot;rotate&quot;:0},&quot;layout&quot;:{&quot;sizeRatio&quot;:{&quot;x&quot;:0.88,&quot;y&quot;:0.88},&quot;keepAspectRatio&quot;:false},&quot;opacity&quot;:1,&quot;path&quot;:{&quot;type&quot;:&quot;RECT&quot;,&quot;size&quot;:{&quot;x&quot;:125.70185644498949,&quot;y&quot;:80.5664380045215},&quot;cornerRounding&quot;:{&quot;type&quot;:&quot;ARC_LENGTH&quot;,&quot;global&quot;:1.754917256457564}},&quot;pathStyles&quot;:[{&quot;type&quot;:&quot;FILL&quot;,&quot;fillStyle&quot;:&quot;rgba(223, 237, 250, 1)&quot;},{&quot;type&quot;:&quot;STROKE&quot;,&quot;strokeStyle&quot;:&quot;rgba(45, 95, 138, 1)&quot;,&quot;lineWidth&quot;:2.2344300486599096,&quot;lineJoin&quot;:&quot;round&quot;}],&quot;isLocked&quot;:false,&quot;parent&quot;:{&quot;type&quot;:&quot;CHILD&quot;,&quot;parentId&quot;:&quot;2d44043c-d176-4440-b2e8-cb14435cb098&quot;,&quot;order&quot;:&quot;4&quot;}},&quot;f2fa1edd-f686-4648-bb9d-5dc9a6954dbe&quot;:{&quot;type&quot;:&quot;FIGURE_OBJECT&quot;,&quot;id&quot;:&quot;f2fa1edd-f686-4648-bb9d-5dc9a6954dbe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5.641010340619367,&quot;color&quot;:&quot;rgba(23,23,23,1)&quot;,&quot;fontWeight&quot;:&quot;normal&quot;,&quot;fontStyle&quot;:&quot;normal&quot;,&quot;decoration&quot;:&quot;none&quot;,&quot;script&quot;:&quot;none&quot;},&quot;range&quot;:[0,45]}],&quot;text&quot;:&quot;Standard Management of Critically ill Patients&quot;}],&quot;verticalAlign&quot;:&quot;TOP&quot;,&quot;_lastCaretLocation&quot;:{&quot;lineIndex&quot;:0,&quot;runIndex&quot;:-1,&quot;charIndex&quot;:-1,&quot;endOfLine&quot;:true}},&quot;size&quot;:{&quot;x&quot;:110.61763367159077,&quot;y&quot;:70.89846544397892},&quot;targetSize&quot;:{&quot;x&quot;:110.61763367159077,&quot;y&quot;:2},&quot;format&quot;:&quot;BETTER_TEXT&quot;},&quot;parent&quot;:{&quot;type&quot;:&quot;CHILD&quot;,&quot;parentId&quot;:&quot;ac5aab61-1b2f-4aa1-8f62-adc4cf6652aa&quot;,&quot;order&quot;:&quot;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49b1bcd6027a75dda608c8c"/>
  <p:tag name="FIGURESLIDEID" val="2d44043c-d176-4440-b2e8-cb14435cb098"/>
  <p:tag name="SELECTIONIDS" val="83692782-8815-456c-9c0b-17967f0056e0"/>
  <p:tag name="TRANSPARENTBACKGROUND" val="true"/>
  <p:tag name="VERSION" val="1741780250768"/>
  <p:tag name="TITLE" val="Untitled"/>
  <p:tag name="CREATORNAME" val="Naomi Pode shakked"/>
  <p:tag name="DATEINSERTED" val="1741780269128"/>
  <p:tag name="DPI" val="300"/>
  <p:tag name="BIOJSON" val="{&quot;id&quot;:&quot;779bf33b-6920-456c-bad9-17caab1086ed&quot;,&quot;objects&quot;:{&quot;83692782-8815-456c-9c0b-17967f0056e0&quot;:{&quot;type&quot;:&quot;FIGURE_OBJECT&quot;,&quot;id&quot;:&quot;83692782-8815-456c-9c0b-17967f0056e0&quot;,&quot;relativeTransform&quot;:{&quot;translate&quot;:{&quot;x&quot;:-1.6109938149872107,&quot;y&quot;:94.16980204715625},&quot;rotate&quot;:0},&quot;opacity&quot;:1,&quot;path&quot;:{&quot;type&quot;:&quot;POLY_LINE&quot;,&quot;points&quot;:[{&quot;x&quot;:-36.93477545060213,&quot;y&quot;:0},{&quot;x&quot;:36.93477545060213,&quot;y&quot;:0}],&quot;closed&quot;:false},&quot;pathStyles&quot;:[{&quot;type&quot;:&quot;FILL&quot;,&quot;fillStyle&quot;:&quot;rgba(0,0,0,0)&quot;},{&quot;type&quot;:&quot;STROKE&quot;,&quot;strokeStyle&quot;:&quot;#232323&quot;,&quot;lineWidth&quot;:2.2344342918976614,&quot;lineJoin&quot;:&quot;round&quot;}],&quot;isLocked&quot;:false,&quot;parent&quot;:{&quot;type&quot;:&quot;CHILD&quot;,&quot;parentId&quot;:&quot;2d44043c-d176-4440-b2e8-cb14435cb098&quot;,&quot;order&quot;:&quot;5&quot;}},&quot;2d44043c-d176-4440-b2e8-cb14435cb098&quot;:{&quot;id&quot;:&quot;2d44043c-d176-4440-b2e8-cb14435cb098&quot;,&quot;type&quot;:&quot;FIGURE_OBJECT&quot;,&quot;document&quot;:{&quot;type&quot;:&quot;FIGURE&quot;,&quot;canvasType&quot;:&quot;FIGURE&quot;,&quot;units&quot;:&quot;in&quot;,&quot;aspectRatio&quot;:0},&quot;parent&quot;:{&quot;type&quot;:&quot;DOCUMENT&quot;,&quot;parentId&quot;:&quot;779bf33b-6920-456c-bad9-17caab1086ed&quot;,&quot;order&quot;:&quot;55&quot;}},&quot;779bf33b-6920-456c-bad9-17caab1086ed&quot;:{&quot;id&quot;:&quot;779bf33b-6920-456c-bad9-17caab1086ed&quot;,&quot;type&quot;:&quot;FIGURE_OBJECT&quot;,&quot;document&quot;:{&quot;type&quot;:&quot;DOCUMENT_GROUP&quot;,&quot;canvasType&quot;:&quot;SLIDE&quot;,&quot;units&quot;:&quot;in&quot;}}}}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48</TotalTime>
  <Words>353</Words>
  <Application>Microsoft Office PowerPoint</Application>
  <PresentationFormat>Widescreen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</vt:lpstr>
      <vt:lpstr>Roboto</vt:lpstr>
      <vt:lpstr>Office Theme</vt:lpstr>
      <vt:lpstr>Serum renin levels refine acute kidney injury prediction in critically ill children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Laycock, Joseph</cp:lastModifiedBy>
  <cp:revision>18</cp:revision>
  <dcterms:created xsi:type="dcterms:W3CDTF">2025-08-16T16:07:30Z</dcterms:created>
  <dcterms:modified xsi:type="dcterms:W3CDTF">2025-11-03T12:52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5-07-11T00:00:00Z</vt:filetime>
  </property>
  <property fmtid="{D5CDD505-2E9C-101B-9397-08002B2CF9AE}" pid="3" name="LastSaved">
    <vt:filetime>2025-08-16T00:00:00Z</vt:filetime>
  </property>
</Properties>
</file>